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B942E71-5666-4BD2-94CD-F52FED490C6C}" v="1" dt="2024-04-11T15:37:15.75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varajan,Eswaran" userId="aad2c616-30ee-4e19-a463-6aea41bf38a4" providerId="ADAL" clId="{DB942E71-5666-4BD2-94CD-F52FED490C6C}"/>
    <pc:docChg chg="modSld">
      <pc:chgData name="Devarajan,Eswaran" userId="aad2c616-30ee-4e19-a463-6aea41bf38a4" providerId="ADAL" clId="{DB942E71-5666-4BD2-94CD-F52FED490C6C}" dt="2024-04-11T15:37:31.535" v="5" actId="1076"/>
      <pc:docMkLst>
        <pc:docMk/>
      </pc:docMkLst>
      <pc:sldChg chg="addSp modSp mod">
        <pc:chgData name="Devarajan,Eswaran" userId="aad2c616-30ee-4e19-a463-6aea41bf38a4" providerId="ADAL" clId="{DB942E71-5666-4BD2-94CD-F52FED490C6C}" dt="2024-04-11T15:37:31.535" v="5" actId="1076"/>
        <pc:sldMkLst>
          <pc:docMk/>
          <pc:sldMk cId="0" sldId="257"/>
        </pc:sldMkLst>
        <pc:spChg chg="add mod">
          <ac:chgData name="Devarajan,Eswaran" userId="aad2c616-30ee-4e19-a463-6aea41bf38a4" providerId="ADAL" clId="{DB942E71-5666-4BD2-94CD-F52FED490C6C}" dt="2024-04-11T15:37:31.535" v="5" actId="1076"/>
          <ac:spMkLst>
            <pc:docMk/>
            <pc:sldMk cId="0" sldId="257"/>
            <ac:spMk id="2" creationId="{AA2C6018-3720-CB0B-80FD-C63B2E69F2F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8853F-D119-4884-8C8C-50EFBDE486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B031187-E30F-4C72-A6D0-4DD0EF5C16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A9E160-1387-4DC2-B654-2A4F0C6C5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E216C-D78F-496F-8DB4-4719FDB49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C6EE83-A467-4F07-A72D-6C3684E93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256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380BC7-8163-42B6-9164-D642AF505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11BC3C-508C-4888-BDFD-1469DF62AD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D39B97-7CA6-43EF-BC8A-316CFC560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E9C8AB-7F5E-4B62-AF58-AFCD61DD4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CBA4B0-105C-48A3-9C40-46CCFBA64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722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D59815-B5BE-4CD7-95D0-64F408AA23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0E8E41-D5CA-446C-BEF4-4A665BDF33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FA50B7-1BF3-404D-A038-25D735B2F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A3729A-3F9A-4077-876E-2A2627F4A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26D5C9-A4CF-4B80-AD0D-DCF3708A1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383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2B0B36-D7BD-42A0-9C45-0184A72293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E8BC2D-4413-4808-B789-80DD793234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457077-C7D5-45C8-BAEA-0CBA9DD55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C8A737-07F7-446F-9004-7DEADD1EF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0F39B3-8ADB-43B6-86FE-245EF108E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173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8D94C9-3349-47B2-9920-2ECD5AEDB2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E60BF3-CC6A-4E9C-8EA8-6305E605CE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F8FE8E-2C8C-4BA8-9E5F-7BE13A97B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CC9E9-5228-4D05-B5EE-49EF2AE288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70E92E-A24A-42D9-9E4F-619809045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481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65364-0012-4F10-90F0-64AF56EA7B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27265F-627D-45AD-9216-9422997D8A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1BE563-359D-4370-BD28-2E333ED80F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A472F7-587A-4236-BCFF-8472F3496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44B48F-490B-4BDE-8970-4F2C9C655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E17D8A-4888-4B99-B0B5-30CA518093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223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042A4F-F833-4EDC-8B8D-EA8009D51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CE1531-F13F-4549-893F-15DBC756DB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B25DDB-FEDB-4703-8E3E-4A8B80F915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2060B31-A361-4832-AF9B-8E72C8A9E5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7E035F-B500-4ED9-B444-406E32490C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71B355-9BDD-44E6-B051-5A8DABB90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BFE5D70-DD66-452D-9354-73535CD77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9AC0E4-55BE-44FA-A037-492D8B504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435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AA5FD5-1B4A-4E59-A4F2-E8EF17E6D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428344-27ED-4994-9663-7531EDBFF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57535A-5548-42A2-B02C-583D0DCB9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6E0A60-75A1-4C3A-91D1-9FF425BAC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209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7C26CC-3AAF-4213-B8B2-C17CDA171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193907-B607-43A8-AE61-D5353C5FD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43257F0-FD2A-49F2-825F-DD268A60B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861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C3C2DC-6B2F-4A82-8D5D-978CA63BB8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9F6173-8372-4B64-A8FF-9697E2BD72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A9548D-347E-4B19-A27B-69251CAF0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921817-1025-495C-B9B4-3D24C0F07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927717-C62D-4894-B943-67E1656A5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82ECD6-06FB-4957-895E-8F0A0E16E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469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BF143D-DCD8-4B89-9944-37A5FD4689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9D1391-0951-4ED2-BB2F-F2109317ED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F39F4D-B504-440E-AE72-4240B9D915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886612-6519-48D1-AF04-12E99C412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F584A0-C223-4F58-AEED-60042D0EA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F36784-A085-46BE-9519-84E56773A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101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6F0BF72-CC22-4C79-8D50-81A72DCDD8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23168D-DDB8-4082-A22A-B6A2AD38DC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90632-2362-4007-B4E7-E9D8CC177C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A77569-ED6D-4177-8EBA-6D4D2F693AFD}" type="datetimeFigureOut">
              <a:rPr lang="en-US" smtClean="0"/>
              <a:t>4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78FB15-C5BA-4813-A39B-F0F95C18FD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50D920-2A91-4A91-BC78-48E3F58F05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279D9-3DA3-49B2-A049-D0A0D228E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022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/>
          <p:nvPr/>
        </p:nvSpPr>
        <p:spPr>
          <a:xfrm>
            <a:off x="435483" y="4389501"/>
            <a:ext cx="11446510" cy="0"/>
          </a:xfrm>
          <a:custGeom>
            <a:avLst/>
            <a:gdLst/>
            <a:ahLst/>
            <a:cxnLst/>
            <a:rect l="l" t="t" r="r" b="b"/>
            <a:pathLst>
              <a:path w="11446510">
                <a:moveTo>
                  <a:pt x="0" y="0"/>
                </a:moveTo>
                <a:lnTo>
                  <a:pt x="11446002" y="0"/>
                </a:lnTo>
              </a:path>
            </a:pathLst>
          </a:custGeom>
          <a:ln w="9906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4" name="object 4"/>
          <p:cNvGrpSpPr/>
          <p:nvPr/>
        </p:nvGrpSpPr>
        <p:grpSpPr>
          <a:xfrm>
            <a:off x="435483" y="2631185"/>
            <a:ext cx="11446510" cy="1510665"/>
            <a:chOff x="435483" y="2631185"/>
            <a:chExt cx="11446510" cy="1510665"/>
          </a:xfrm>
        </p:grpSpPr>
        <p:sp>
          <p:nvSpPr>
            <p:cNvPr id="5" name="object 5"/>
            <p:cNvSpPr/>
            <p:nvPr/>
          </p:nvSpPr>
          <p:spPr>
            <a:xfrm>
              <a:off x="435483" y="4033646"/>
              <a:ext cx="2453640" cy="3810"/>
            </a:xfrm>
            <a:custGeom>
              <a:avLst/>
              <a:gdLst/>
              <a:ahLst/>
              <a:cxnLst/>
              <a:rect l="l" t="t" r="r" b="b"/>
              <a:pathLst>
                <a:path w="2453640" h="3810">
                  <a:moveTo>
                    <a:pt x="0" y="0"/>
                  </a:moveTo>
                  <a:lnTo>
                    <a:pt x="2453259" y="0"/>
                  </a:lnTo>
                </a:path>
                <a:path w="2453640" h="3810">
                  <a:moveTo>
                    <a:pt x="0" y="3809"/>
                  </a:moveTo>
                  <a:lnTo>
                    <a:pt x="2453259" y="3809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435483" y="4042028"/>
              <a:ext cx="2453640" cy="0"/>
            </a:xfrm>
            <a:custGeom>
              <a:avLst/>
              <a:gdLst/>
              <a:ahLst/>
              <a:cxnLst/>
              <a:rect l="l" t="t" r="r" b="b"/>
              <a:pathLst>
                <a:path w="2453640">
                  <a:moveTo>
                    <a:pt x="0" y="0"/>
                  </a:moveTo>
                  <a:lnTo>
                    <a:pt x="2453259" y="0"/>
                  </a:lnTo>
                </a:path>
              </a:pathLst>
            </a:custGeom>
            <a:ln w="7620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435483" y="3685412"/>
              <a:ext cx="427355" cy="0"/>
            </a:xfrm>
            <a:custGeom>
              <a:avLst/>
              <a:gdLst/>
              <a:ahLst/>
              <a:cxnLst/>
              <a:rect l="l" t="t" r="r" b="b"/>
              <a:pathLst>
                <a:path w="427355">
                  <a:moveTo>
                    <a:pt x="0" y="0"/>
                  </a:moveTo>
                  <a:lnTo>
                    <a:pt x="427101" y="0"/>
                  </a:lnTo>
                </a:path>
              </a:pathLst>
            </a:custGeom>
            <a:ln w="5333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435483" y="3690556"/>
              <a:ext cx="252095" cy="0"/>
            </a:xfrm>
            <a:custGeom>
              <a:avLst/>
              <a:gdLst/>
              <a:ahLst/>
              <a:cxnLst/>
              <a:rect l="l" t="t" r="r" b="b"/>
              <a:pathLst>
                <a:path w="252095">
                  <a:moveTo>
                    <a:pt x="0" y="0"/>
                  </a:moveTo>
                  <a:lnTo>
                    <a:pt x="251840" y="0"/>
                  </a:lnTo>
                </a:path>
              </a:pathLst>
            </a:custGeom>
            <a:ln w="4952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931926" y="3685412"/>
              <a:ext cx="1472565" cy="0"/>
            </a:xfrm>
            <a:custGeom>
              <a:avLst/>
              <a:gdLst/>
              <a:ahLst/>
              <a:cxnLst/>
              <a:rect l="l" t="t" r="r" b="b"/>
              <a:pathLst>
                <a:path w="1472564">
                  <a:moveTo>
                    <a:pt x="0" y="0"/>
                  </a:moveTo>
                  <a:lnTo>
                    <a:pt x="327660" y="0"/>
                  </a:lnTo>
                </a:path>
                <a:path w="1472564">
                  <a:moveTo>
                    <a:pt x="397002" y="0"/>
                  </a:moveTo>
                  <a:lnTo>
                    <a:pt x="899922" y="0"/>
                  </a:lnTo>
                </a:path>
                <a:path w="1472564">
                  <a:moveTo>
                    <a:pt x="969264" y="0"/>
                  </a:moveTo>
                  <a:lnTo>
                    <a:pt x="1472184" y="0"/>
                  </a:lnTo>
                </a:path>
              </a:pathLst>
            </a:custGeom>
            <a:ln w="5333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755904" y="3690556"/>
              <a:ext cx="1560195" cy="0"/>
            </a:xfrm>
            <a:custGeom>
              <a:avLst/>
              <a:gdLst/>
              <a:ahLst/>
              <a:cxnLst/>
              <a:rect l="l" t="t" r="r" b="b"/>
              <a:pathLst>
                <a:path w="1560195">
                  <a:moveTo>
                    <a:pt x="0" y="0"/>
                  </a:moveTo>
                  <a:lnTo>
                    <a:pt x="1251204" y="0"/>
                  </a:lnTo>
                </a:path>
                <a:path w="1560195">
                  <a:moveTo>
                    <a:pt x="1320546" y="0"/>
                  </a:moveTo>
                  <a:lnTo>
                    <a:pt x="1472184" y="0"/>
                  </a:lnTo>
                </a:path>
                <a:path w="1560195">
                  <a:moveTo>
                    <a:pt x="1541526" y="0"/>
                  </a:moveTo>
                  <a:lnTo>
                    <a:pt x="1559814" y="0"/>
                  </a:lnTo>
                </a:path>
              </a:pathLst>
            </a:custGeom>
            <a:ln w="4952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2473452" y="3685412"/>
              <a:ext cx="502920" cy="0"/>
            </a:xfrm>
            <a:custGeom>
              <a:avLst/>
              <a:gdLst/>
              <a:ahLst/>
              <a:cxnLst/>
              <a:rect l="l" t="t" r="r" b="b"/>
              <a:pathLst>
                <a:path w="502919">
                  <a:moveTo>
                    <a:pt x="0" y="0"/>
                  </a:moveTo>
                  <a:lnTo>
                    <a:pt x="502919" y="0"/>
                  </a:lnTo>
                </a:path>
              </a:pathLst>
            </a:custGeom>
            <a:ln w="5333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2385059" y="3690556"/>
              <a:ext cx="504190" cy="0"/>
            </a:xfrm>
            <a:custGeom>
              <a:avLst/>
              <a:gdLst/>
              <a:ahLst/>
              <a:cxnLst/>
              <a:rect l="l" t="t" r="r" b="b"/>
              <a:pathLst>
                <a:path w="504189">
                  <a:moveTo>
                    <a:pt x="0" y="0"/>
                  </a:moveTo>
                  <a:lnTo>
                    <a:pt x="106679" y="0"/>
                  </a:lnTo>
                </a:path>
                <a:path w="504189">
                  <a:moveTo>
                    <a:pt x="176021" y="0"/>
                  </a:moveTo>
                  <a:lnTo>
                    <a:pt x="194309" y="0"/>
                  </a:lnTo>
                </a:path>
                <a:path w="504189">
                  <a:moveTo>
                    <a:pt x="263651" y="0"/>
                  </a:moveTo>
                  <a:lnTo>
                    <a:pt x="415289" y="0"/>
                  </a:lnTo>
                </a:path>
                <a:path w="504189">
                  <a:moveTo>
                    <a:pt x="484631" y="0"/>
                  </a:moveTo>
                  <a:lnTo>
                    <a:pt x="503681" y="0"/>
                  </a:lnTo>
                </a:path>
              </a:pathLst>
            </a:custGeom>
            <a:ln w="4952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3045713" y="3685412"/>
              <a:ext cx="106680" cy="0"/>
            </a:xfrm>
            <a:custGeom>
              <a:avLst/>
              <a:gdLst/>
              <a:ahLst/>
              <a:cxnLst/>
              <a:rect l="l" t="t" r="r" b="b"/>
              <a:pathLst>
                <a:path w="106680">
                  <a:moveTo>
                    <a:pt x="0" y="0"/>
                  </a:moveTo>
                  <a:lnTo>
                    <a:pt x="106679" y="0"/>
                  </a:lnTo>
                </a:path>
              </a:pathLst>
            </a:custGeom>
            <a:ln w="5333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2957322" y="3690556"/>
              <a:ext cx="106680" cy="0"/>
            </a:xfrm>
            <a:custGeom>
              <a:avLst/>
              <a:gdLst/>
              <a:ahLst/>
              <a:cxnLst/>
              <a:rect l="l" t="t" r="r" b="b"/>
              <a:pathLst>
                <a:path w="106680">
                  <a:moveTo>
                    <a:pt x="0" y="0"/>
                  </a:moveTo>
                  <a:lnTo>
                    <a:pt x="106679" y="0"/>
                  </a:lnTo>
                </a:path>
              </a:pathLst>
            </a:custGeom>
            <a:ln w="4952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3220974" y="3685412"/>
              <a:ext cx="723900" cy="0"/>
            </a:xfrm>
            <a:custGeom>
              <a:avLst/>
              <a:gdLst/>
              <a:ahLst/>
              <a:cxnLst/>
              <a:rect l="l" t="t" r="r" b="b"/>
              <a:pathLst>
                <a:path w="723900">
                  <a:moveTo>
                    <a:pt x="0" y="0"/>
                  </a:moveTo>
                  <a:lnTo>
                    <a:pt x="723900" y="0"/>
                  </a:lnTo>
                </a:path>
              </a:pathLst>
            </a:custGeom>
            <a:ln w="5333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3133343" y="3690556"/>
              <a:ext cx="591820" cy="0"/>
            </a:xfrm>
            <a:custGeom>
              <a:avLst/>
              <a:gdLst/>
              <a:ahLst/>
              <a:cxnLst/>
              <a:rect l="l" t="t" r="r" b="b"/>
              <a:pathLst>
                <a:path w="591820">
                  <a:moveTo>
                    <a:pt x="0" y="0"/>
                  </a:moveTo>
                  <a:lnTo>
                    <a:pt x="239268" y="0"/>
                  </a:lnTo>
                </a:path>
                <a:path w="591820">
                  <a:moveTo>
                    <a:pt x="308609" y="0"/>
                  </a:moveTo>
                  <a:lnTo>
                    <a:pt x="327659" y="0"/>
                  </a:lnTo>
                </a:path>
                <a:path w="591820">
                  <a:moveTo>
                    <a:pt x="396239" y="0"/>
                  </a:moveTo>
                  <a:lnTo>
                    <a:pt x="415290" y="0"/>
                  </a:lnTo>
                </a:path>
                <a:path w="591820">
                  <a:moveTo>
                    <a:pt x="484631" y="0"/>
                  </a:moveTo>
                  <a:lnTo>
                    <a:pt x="591311" y="0"/>
                  </a:lnTo>
                </a:path>
              </a:pathLst>
            </a:custGeom>
            <a:ln w="4952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4014216" y="3685412"/>
              <a:ext cx="1823720" cy="0"/>
            </a:xfrm>
            <a:custGeom>
              <a:avLst/>
              <a:gdLst/>
              <a:ahLst/>
              <a:cxnLst/>
              <a:rect l="l" t="t" r="r" b="b"/>
              <a:pathLst>
                <a:path w="1823720">
                  <a:moveTo>
                    <a:pt x="0" y="0"/>
                  </a:moveTo>
                  <a:lnTo>
                    <a:pt x="19050" y="0"/>
                  </a:lnTo>
                </a:path>
                <a:path w="1823720">
                  <a:moveTo>
                    <a:pt x="87629" y="0"/>
                  </a:moveTo>
                  <a:lnTo>
                    <a:pt x="106680" y="0"/>
                  </a:lnTo>
                </a:path>
                <a:path w="1823720">
                  <a:moveTo>
                    <a:pt x="176022" y="0"/>
                  </a:moveTo>
                  <a:lnTo>
                    <a:pt x="194310" y="0"/>
                  </a:lnTo>
                </a:path>
                <a:path w="1823720">
                  <a:moveTo>
                    <a:pt x="263651" y="0"/>
                  </a:moveTo>
                  <a:lnTo>
                    <a:pt x="282701" y="0"/>
                  </a:lnTo>
                </a:path>
                <a:path w="1823720">
                  <a:moveTo>
                    <a:pt x="351281" y="0"/>
                  </a:moveTo>
                  <a:lnTo>
                    <a:pt x="502920" y="0"/>
                  </a:lnTo>
                </a:path>
                <a:path w="1823720">
                  <a:moveTo>
                    <a:pt x="572262" y="0"/>
                  </a:moveTo>
                  <a:lnTo>
                    <a:pt x="591312" y="0"/>
                  </a:lnTo>
                </a:path>
                <a:path w="1823720">
                  <a:moveTo>
                    <a:pt x="659891" y="0"/>
                  </a:moveTo>
                  <a:lnTo>
                    <a:pt x="678942" y="0"/>
                  </a:lnTo>
                </a:path>
                <a:path w="1823720">
                  <a:moveTo>
                    <a:pt x="748284" y="0"/>
                  </a:moveTo>
                  <a:lnTo>
                    <a:pt x="766572" y="0"/>
                  </a:lnTo>
                </a:path>
                <a:path w="1823720">
                  <a:moveTo>
                    <a:pt x="835913" y="0"/>
                  </a:moveTo>
                  <a:lnTo>
                    <a:pt x="854963" y="0"/>
                  </a:lnTo>
                </a:path>
                <a:path w="1823720">
                  <a:moveTo>
                    <a:pt x="923543" y="0"/>
                  </a:moveTo>
                  <a:lnTo>
                    <a:pt x="1075182" y="0"/>
                  </a:lnTo>
                </a:path>
                <a:path w="1823720">
                  <a:moveTo>
                    <a:pt x="1144524" y="0"/>
                  </a:moveTo>
                  <a:lnTo>
                    <a:pt x="1163574" y="0"/>
                  </a:lnTo>
                </a:path>
                <a:path w="1823720">
                  <a:moveTo>
                    <a:pt x="1232915" y="0"/>
                  </a:moveTo>
                  <a:lnTo>
                    <a:pt x="1251204" y="0"/>
                  </a:lnTo>
                </a:path>
                <a:path w="1823720">
                  <a:moveTo>
                    <a:pt x="1320546" y="0"/>
                  </a:moveTo>
                  <a:lnTo>
                    <a:pt x="1338834" y="0"/>
                  </a:lnTo>
                </a:path>
                <a:path w="1823720">
                  <a:moveTo>
                    <a:pt x="1408176" y="0"/>
                  </a:moveTo>
                  <a:lnTo>
                    <a:pt x="1427226" y="0"/>
                  </a:lnTo>
                </a:path>
                <a:path w="1823720">
                  <a:moveTo>
                    <a:pt x="1496567" y="0"/>
                  </a:moveTo>
                  <a:lnTo>
                    <a:pt x="1823466" y="0"/>
                  </a:lnTo>
                </a:path>
              </a:pathLst>
            </a:custGeom>
            <a:ln w="5333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3793236" y="3690556"/>
              <a:ext cx="1957070" cy="0"/>
            </a:xfrm>
            <a:custGeom>
              <a:avLst/>
              <a:gdLst/>
              <a:ahLst/>
              <a:cxnLst/>
              <a:rect l="l" t="t" r="r" b="b"/>
              <a:pathLst>
                <a:path w="1957070">
                  <a:moveTo>
                    <a:pt x="0" y="0"/>
                  </a:moveTo>
                  <a:lnTo>
                    <a:pt x="1868424" y="0"/>
                  </a:lnTo>
                </a:path>
                <a:path w="1957070">
                  <a:moveTo>
                    <a:pt x="1937766" y="0"/>
                  </a:moveTo>
                  <a:lnTo>
                    <a:pt x="1956816" y="0"/>
                  </a:lnTo>
                </a:path>
              </a:pathLst>
            </a:custGeom>
            <a:ln w="4952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5907023" y="3685412"/>
              <a:ext cx="502920" cy="0"/>
            </a:xfrm>
            <a:custGeom>
              <a:avLst/>
              <a:gdLst/>
              <a:ahLst/>
              <a:cxnLst/>
              <a:rect l="l" t="t" r="r" b="b"/>
              <a:pathLst>
                <a:path w="502920">
                  <a:moveTo>
                    <a:pt x="0" y="0"/>
                  </a:moveTo>
                  <a:lnTo>
                    <a:pt x="502920" y="0"/>
                  </a:lnTo>
                </a:path>
              </a:pathLst>
            </a:custGeom>
            <a:ln w="5333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5819393" y="3690556"/>
              <a:ext cx="502920" cy="0"/>
            </a:xfrm>
            <a:custGeom>
              <a:avLst/>
              <a:gdLst/>
              <a:ahLst/>
              <a:cxnLst/>
              <a:rect l="l" t="t" r="r" b="b"/>
              <a:pathLst>
                <a:path w="502920">
                  <a:moveTo>
                    <a:pt x="0" y="0"/>
                  </a:moveTo>
                  <a:lnTo>
                    <a:pt x="105918" y="0"/>
                  </a:lnTo>
                </a:path>
                <a:path w="502920">
                  <a:moveTo>
                    <a:pt x="175260" y="0"/>
                  </a:moveTo>
                  <a:lnTo>
                    <a:pt x="194310" y="0"/>
                  </a:lnTo>
                </a:path>
                <a:path w="502920">
                  <a:moveTo>
                    <a:pt x="263651" y="0"/>
                  </a:moveTo>
                  <a:lnTo>
                    <a:pt x="414528" y="0"/>
                  </a:lnTo>
                </a:path>
                <a:path w="502920">
                  <a:moveTo>
                    <a:pt x="483870" y="0"/>
                  </a:moveTo>
                  <a:lnTo>
                    <a:pt x="502920" y="0"/>
                  </a:lnTo>
                </a:path>
              </a:pathLst>
            </a:custGeom>
            <a:ln w="4952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6479286" y="3685412"/>
              <a:ext cx="591820" cy="0"/>
            </a:xfrm>
            <a:custGeom>
              <a:avLst/>
              <a:gdLst/>
              <a:ahLst/>
              <a:cxnLst/>
              <a:rect l="l" t="t" r="r" b="b"/>
              <a:pathLst>
                <a:path w="591820">
                  <a:moveTo>
                    <a:pt x="0" y="0"/>
                  </a:moveTo>
                  <a:lnTo>
                    <a:pt x="18287" y="0"/>
                  </a:lnTo>
                </a:path>
                <a:path w="591820">
                  <a:moveTo>
                    <a:pt x="87630" y="0"/>
                  </a:moveTo>
                  <a:lnTo>
                    <a:pt x="106680" y="0"/>
                  </a:lnTo>
                </a:path>
                <a:path w="591820">
                  <a:moveTo>
                    <a:pt x="176022" y="0"/>
                  </a:moveTo>
                  <a:lnTo>
                    <a:pt x="591312" y="0"/>
                  </a:lnTo>
                </a:path>
              </a:pathLst>
            </a:custGeom>
            <a:ln w="5333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6391655" y="3690556"/>
              <a:ext cx="502920" cy="0"/>
            </a:xfrm>
            <a:custGeom>
              <a:avLst/>
              <a:gdLst/>
              <a:ahLst/>
              <a:cxnLst/>
              <a:rect l="l" t="t" r="r" b="b"/>
              <a:pathLst>
                <a:path w="502920">
                  <a:moveTo>
                    <a:pt x="0" y="0"/>
                  </a:moveTo>
                  <a:lnTo>
                    <a:pt x="415290" y="0"/>
                  </a:lnTo>
                </a:path>
                <a:path w="502920">
                  <a:moveTo>
                    <a:pt x="483870" y="0"/>
                  </a:moveTo>
                  <a:lnTo>
                    <a:pt x="502920" y="0"/>
                  </a:lnTo>
                </a:path>
              </a:pathLst>
            </a:custGeom>
            <a:ln w="4952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7139177" y="3685412"/>
              <a:ext cx="4742815" cy="0"/>
            </a:xfrm>
            <a:custGeom>
              <a:avLst/>
              <a:gdLst/>
              <a:ahLst/>
              <a:cxnLst/>
              <a:rect l="l" t="t" r="r" b="b"/>
              <a:pathLst>
                <a:path w="4742815">
                  <a:moveTo>
                    <a:pt x="0" y="0"/>
                  </a:moveTo>
                  <a:lnTo>
                    <a:pt x="240029" y="0"/>
                  </a:lnTo>
                </a:path>
                <a:path w="4742815">
                  <a:moveTo>
                    <a:pt x="308609" y="0"/>
                  </a:moveTo>
                  <a:lnTo>
                    <a:pt x="327660" y="0"/>
                  </a:lnTo>
                </a:path>
                <a:path w="4742815">
                  <a:moveTo>
                    <a:pt x="397002" y="0"/>
                  </a:moveTo>
                  <a:lnTo>
                    <a:pt x="503681" y="0"/>
                  </a:lnTo>
                </a:path>
                <a:path w="4742815">
                  <a:moveTo>
                    <a:pt x="572261" y="0"/>
                  </a:moveTo>
                  <a:lnTo>
                    <a:pt x="591312" y="0"/>
                  </a:lnTo>
                </a:path>
                <a:path w="4742815">
                  <a:moveTo>
                    <a:pt x="660654" y="0"/>
                  </a:moveTo>
                  <a:lnTo>
                    <a:pt x="812292" y="0"/>
                  </a:lnTo>
                </a:path>
                <a:path w="4742815">
                  <a:moveTo>
                    <a:pt x="880872" y="0"/>
                  </a:moveTo>
                  <a:lnTo>
                    <a:pt x="899922" y="0"/>
                  </a:lnTo>
                </a:path>
                <a:path w="4742815">
                  <a:moveTo>
                    <a:pt x="969264" y="0"/>
                  </a:moveTo>
                  <a:lnTo>
                    <a:pt x="987551" y="0"/>
                  </a:lnTo>
                </a:path>
                <a:path w="4742815">
                  <a:moveTo>
                    <a:pt x="1056894" y="0"/>
                  </a:moveTo>
                  <a:lnTo>
                    <a:pt x="1075944" y="0"/>
                  </a:lnTo>
                </a:path>
                <a:path w="4742815">
                  <a:moveTo>
                    <a:pt x="1144524" y="0"/>
                  </a:moveTo>
                  <a:lnTo>
                    <a:pt x="1163574" y="0"/>
                  </a:lnTo>
                </a:path>
                <a:path w="4742815">
                  <a:moveTo>
                    <a:pt x="1232916" y="0"/>
                  </a:moveTo>
                  <a:lnTo>
                    <a:pt x="1384553" y="0"/>
                  </a:lnTo>
                </a:path>
                <a:path w="4742815">
                  <a:moveTo>
                    <a:pt x="1453133" y="0"/>
                  </a:moveTo>
                  <a:lnTo>
                    <a:pt x="1472183" y="0"/>
                  </a:lnTo>
                </a:path>
                <a:path w="4742815">
                  <a:moveTo>
                    <a:pt x="1541526" y="0"/>
                  </a:moveTo>
                  <a:lnTo>
                    <a:pt x="1559814" y="0"/>
                  </a:lnTo>
                </a:path>
                <a:path w="4742815">
                  <a:moveTo>
                    <a:pt x="1629156" y="0"/>
                  </a:moveTo>
                  <a:lnTo>
                    <a:pt x="1648205" y="0"/>
                  </a:lnTo>
                </a:path>
                <a:path w="4742815">
                  <a:moveTo>
                    <a:pt x="1716785" y="0"/>
                  </a:moveTo>
                  <a:lnTo>
                    <a:pt x="1735836" y="0"/>
                  </a:lnTo>
                </a:path>
                <a:path w="4742815">
                  <a:moveTo>
                    <a:pt x="1805178" y="0"/>
                  </a:moveTo>
                  <a:lnTo>
                    <a:pt x="1956816" y="0"/>
                  </a:lnTo>
                </a:path>
                <a:path w="4742815">
                  <a:moveTo>
                    <a:pt x="2026158" y="0"/>
                  </a:moveTo>
                  <a:lnTo>
                    <a:pt x="2044446" y="0"/>
                  </a:lnTo>
                </a:path>
                <a:path w="4742815">
                  <a:moveTo>
                    <a:pt x="2113788" y="0"/>
                  </a:moveTo>
                  <a:lnTo>
                    <a:pt x="2132076" y="0"/>
                  </a:lnTo>
                </a:path>
                <a:path w="4742815">
                  <a:moveTo>
                    <a:pt x="2201418" y="0"/>
                  </a:moveTo>
                  <a:lnTo>
                    <a:pt x="2220468" y="0"/>
                  </a:lnTo>
                </a:path>
                <a:path w="4742815">
                  <a:moveTo>
                    <a:pt x="2289810" y="0"/>
                  </a:moveTo>
                  <a:lnTo>
                    <a:pt x="2308098" y="0"/>
                  </a:lnTo>
                </a:path>
                <a:path w="4742815">
                  <a:moveTo>
                    <a:pt x="2377440" y="0"/>
                  </a:moveTo>
                  <a:lnTo>
                    <a:pt x="2529078" y="0"/>
                  </a:lnTo>
                </a:path>
                <a:path w="4742815">
                  <a:moveTo>
                    <a:pt x="2598420" y="0"/>
                  </a:moveTo>
                  <a:lnTo>
                    <a:pt x="2616707" y="0"/>
                  </a:lnTo>
                </a:path>
                <a:path w="4742815">
                  <a:moveTo>
                    <a:pt x="2686050" y="0"/>
                  </a:moveTo>
                  <a:lnTo>
                    <a:pt x="2704338" y="0"/>
                  </a:lnTo>
                </a:path>
                <a:path w="4742815">
                  <a:moveTo>
                    <a:pt x="2773680" y="0"/>
                  </a:moveTo>
                  <a:lnTo>
                    <a:pt x="2792729" y="0"/>
                  </a:lnTo>
                </a:path>
                <a:path w="4742815">
                  <a:moveTo>
                    <a:pt x="2862072" y="0"/>
                  </a:moveTo>
                  <a:lnTo>
                    <a:pt x="2880360" y="0"/>
                  </a:lnTo>
                </a:path>
                <a:path w="4742815">
                  <a:moveTo>
                    <a:pt x="2949702" y="0"/>
                  </a:moveTo>
                  <a:lnTo>
                    <a:pt x="3101340" y="0"/>
                  </a:lnTo>
                </a:path>
                <a:path w="4742815">
                  <a:moveTo>
                    <a:pt x="3170682" y="0"/>
                  </a:moveTo>
                  <a:lnTo>
                    <a:pt x="3188970" y="0"/>
                  </a:lnTo>
                </a:path>
                <a:path w="4742815">
                  <a:moveTo>
                    <a:pt x="3258312" y="0"/>
                  </a:moveTo>
                  <a:lnTo>
                    <a:pt x="3276600" y="0"/>
                  </a:lnTo>
                </a:path>
                <a:path w="4742815">
                  <a:moveTo>
                    <a:pt x="3345942" y="0"/>
                  </a:moveTo>
                  <a:lnTo>
                    <a:pt x="3364992" y="0"/>
                  </a:lnTo>
                </a:path>
                <a:path w="4742815">
                  <a:moveTo>
                    <a:pt x="3434334" y="0"/>
                  </a:moveTo>
                  <a:lnTo>
                    <a:pt x="3452622" y="0"/>
                  </a:lnTo>
                </a:path>
                <a:path w="4742815">
                  <a:moveTo>
                    <a:pt x="3521964" y="0"/>
                  </a:moveTo>
                  <a:lnTo>
                    <a:pt x="3673602" y="0"/>
                  </a:lnTo>
                </a:path>
                <a:path w="4742815">
                  <a:moveTo>
                    <a:pt x="3742944" y="0"/>
                  </a:moveTo>
                  <a:lnTo>
                    <a:pt x="3761231" y="0"/>
                  </a:lnTo>
                </a:path>
                <a:path w="4742815">
                  <a:moveTo>
                    <a:pt x="3830574" y="0"/>
                  </a:moveTo>
                  <a:lnTo>
                    <a:pt x="3849624" y="0"/>
                  </a:lnTo>
                </a:path>
                <a:path w="4742815">
                  <a:moveTo>
                    <a:pt x="3918204" y="0"/>
                  </a:moveTo>
                  <a:lnTo>
                    <a:pt x="3937254" y="0"/>
                  </a:lnTo>
                </a:path>
                <a:path w="4742815">
                  <a:moveTo>
                    <a:pt x="4006596" y="0"/>
                  </a:moveTo>
                  <a:lnTo>
                    <a:pt x="4024883" y="0"/>
                  </a:lnTo>
                </a:path>
                <a:path w="4742815">
                  <a:moveTo>
                    <a:pt x="4094226" y="0"/>
                  </a:moveTo>
                  <a:lnTo>
                    <a:pt x="4245864" y="0"/>
                  </a:lnTo>
                </a:path>
                <a:path w="4742815">
                  <a:moveTo>
                    <a:pt x="4315206" y="0"/>
                  </a:moveTo>
                  <a:lnTo>
                    <a:pt x="4333494" y="0"/>
                  </a:lnTo>
                </a:path>
                <a:path w="4742815">
                  <a:moveTo>
                    <a:pt x="4402836" y="0"/>
                  </a:moveTo>
                  <a:lnTo>
                    <a:pt x="4421886" y="0"/>
                  </a:lnTo>
                </a:path>
                <a:path w="4742815">
                  <a:moveTo>
                    <a:pt x="4490466" y="0"/>
                  </a:moveTo>
                  <a:lnTo>
                    <a:pt x="4509516" y="0"/>
                  </a:lnTo>
                </a:path>
                <a:path w="4742815">
                  <a:moveTo>
                    <a:pt x="4578858" y="0"/>
                  </a:moveTo>
                  <a:lnTo>
                    <a:pt x="4597146" y="0"/>
                  </a:lnTo>
                </a:path>
                <a:path w="4742815">
                  <a:moveTo>
                    <a:pt x="4666488" y="0"/>
                  </a:moveTo>
                  <a:lnTo>
                    <a:pt x="4742307" y="0"/>
                  </a:lnTo>
                </a:path>
              </a:pathLst>
            </a:custGeom>
            <a:ln w="5333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6963917" y="3690556"/>
              <a:ext cx="4918075" cy="0"/>
            </a:xfrm>
            <a:custGeom>
              <a:avLst/>
              <a:gdLst/>
              <a:ahLst/>
              <a:cxnLst/>
              <a:rect l="l" t="t" r="r" b="b"/>
              <a:pathLst>
                <a:path w="4918075">
                  <a:moveTo>
                    <a:pt x="0" y="0"/>
                  </a:moveTo>
                  <a:lnTo>
                    <a:pt x="4917566" y="0"/>
                  </a:lnTo>
                </a:path>
              </a:pathLst>
            </a:custGeom>
            <a:ln w="4952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435483" y="3686746"/>
              <a:ext cx="11446510" cy="2540"/>
            </a:xfrm>
            <a:custGeom>
              <a:avLst/>
              <a:gdLst/>
              <a:ahLst/>
              <a:cxnLst/>
              <a:rect l="l" t="t" r="r" b="b"/>
              <a:pathLst>
                <a:path w="11446510" h="2539">
                  <a:moveTo>
                    <a:pt x="0" y="2476"/>
                  </a:moveTo>
                  <a:lnTo>
                    <a:pt x="251840" y="2476"/>
                  </a:lnTo>
                </a:path>
                <a:path w="11446510" h="2539">
                  <a:moveTo>
                    <a:pt x="320420" y="2476"/>
                  </a:moveTo>
                  <a:lnTo>
                    <a:pt x="1571625" y="2476"/>
                  </a:lnTo>
                </a:path>
                <a:path w="11446510" h="2539">
                  <a:moveTo>
                    <a:pt x="1640967" y="2476"/>
                  </a:moveTo>
                  <a:lnTo>
                    <a:pt x="1880235" y="2476"/>
                  </a:lnTo>
                </a:path>
                <a:path w="11446510" h="2539">
                  <a:moveTo>
                    <a:pt x="1949577" y="2476"/>
                  </a:moveTo>
                  <a:lnTo>
                    <a:pt x="2056257" y="2476"/>
                  </a:lnTo>
                </a:path>
                <a:path w="11446510" h="2539">
                  <a:moveTo>
                    <a:pt x="2125599" y="2476"/>
                  </a:moveTo>
                  <a:lnTo>
                    <a:pt x="2143887" y="2476"/>
                  </a:lnTo>
                </a:path>
                <a:path w="11446510" h="2539">
                  <a:moveTo>
                    <a:pt x="2213229" y="2476"/>
                  </a:moveTo>
                  <a:lnTo>
                    <a:pt x="2364867" y="2476"/>
                  </a:lnTo>
                </a:path>
                <a:path w="11446510" h="2539">
                  <a:moveTo>
                    <a:pt x="2434209" y="2476"/>
                  </a:moveTo>
                  <a:lnTo>
                    <a:pt x="2453259" y="2476"/>
                  </a:lnTo>
                </a:path>
                <a:path w="11446510" h="2539">
                  <a:moveTo>
                    <a:pt x="2521839" y="2476"/>
                  </a:moveTo>
                  <a:lnTo>
                    <a:pt x="2628519" y="2476"/>
                  </a:lnTo>
                </a:path>
                <a:path w="11446510" h="2539">
                  <a:moveTo>
                    <a:pt x="2697861" y="2476"/>
                  </a:moveTo>
                  <a:lnTo>
                    <a:pt x="2937129" y="2476"/>
                  </a:lnTo>
                </a:path>
                <a:path w="11446510" h="2539">
                  <a:moveTo>
                    <a:pt x="3006471" y="2476"/>
                  </a:moveTo>
                  <a:lnTo>
                    <a:pt x="3025521" y="2476"/>
                  </a:lnTo>
                </a:path>
                <a:path w="11446510" h="2539">
                  <a:moveTo>
                    <a:pt x="3094100" y="2476"/>
                  </a:moveTo>
                  <a:lnTo>
                    <a:pt x="3113151" y="2476"/>
                  </a:lnTo>
                </a:path>
                <a:path w="11446510" h="2539">
                  <a:moveTo>
                    <a:pt x="3182493" y="2476"/>
                  </a:moveTo>
                  <a:lnTo>
                    <a:pt x="3289172" y="2476"/>
                  </a:lnTo>
                </a:path>
                <a:path w="11446510" h="2539">
                  <a:moveTo>
                    <a:pt x="3357752" y="2476"/>
                  </a:moveTo>
                  <a:lnTo>
                    <a:pt x="5226177" y="2476"/>
                  </a:lnTo>
                </a:path>
                <a:path w="11446510" h="2539">
                  <a:moveTo>
                    <a:pt x="5295519" y="2476"/>
                  </a:moveTo>
                  <a:lnTo>
                    <a:pt x="5314569" y="2476"/>
                  </a:lnTo>
                </a:path>
                <a:path w="11446510" h="2539">
                  <a:moveTo>
                    <a:pt x="5383910" y="2476"/>
                  </a:moveTo>
                  <a:lnTo>
                    <a:pt x="5489829" y="2476"/>
                  </a:lnTo>
                </a:path>
                <a:path w="11446510" h="2539">
                  <a:moveTo>
                    <a:pt x="5559170" y="2476"/>
                  </a:moveTo>
                  <a:lnTo>
                    <a:pt x="5578220" y="2476"/>
                  </a:lnTo>
                </a:path>
                <a:path w="11446510" h="2539">
                  <a:moveTo>
                    <a:pt x="5647562" y="2476"/>
                  </a:moveTo>
                  <a:lnTo>
                    <a:pt x="5798439" y="2476"/>
                  </a:lnTo>
                </a:path>
                <a:path w="11446510" h="2539">
                  <a:moveTo>
                    <a:pt x="5867781" y="2476"/>
                  </a:moveTo>
                  <a:lnTo>
                    <a:pt x="5886831" y="2476"/>
                  </a:lnTo>
                </a:path>
                <a:path w="11446510" h="2539">
                  <a:moveTo>
                    <a:pt x="5956172" y="2476"/>
                  </a:moveTo>
                  <a:lnTo>
                    <a:pt x="6371463" y="2476"/>
                  </a:lnTo>
                </a:path>
                <a:path w="11446510" h="2539">
                  <a:moveTo>
                    <a:pt x="6440043" y="2476"/>
                  </a:moveTo>
                  <a:lnTo>
                    <a:pt x="6459093" y="2476"/>
                  </a:lnTo>
                </a:path>
                <a:path w="11446510" h="2539">
                  <a:moveTo>
                    <a:pt x="6528435" y="2476"/>
                  </a:moveTo>
                  <a:lnTo>
                    <a:pt x="11446002" y="2476"/>
                  </a:lnTo>
                </a:path>
                <a:path w="11446510" h="2539">
                  <a:moveTo>
                    <a:pt x="0" y="0"/>
                  </a:moveTo>
                  <a:lnTo>
                    <a:pt x="427101" y="0"/>
                  </a:lnTo>
                </a:path>
                <a:path w="11446510" h="2539">
                  <a:moveTo>
                    <a:pt x="496442" y="0"/>
                  </a:moveTo>
                  <a:lnTo>
                    <a:pt x="824103" y="0"/>
                  </a:lnTo>
                </a:path>
                <a:path w="11446510" h="2539">
                  <a:moveTo>
                    <a:pt x="893444" y="0"/>
                  </a:moveTo>
                  <a:lnTo>
                    <a:pt x="1396365" y="0"/>
                  </a:lnTo>
                </a:path>
                <a:path w="11446510" h="2539">
                  <a:moveTo>
                    <a:pt x="1465707" y="0"/>
                  </a:moveTo>
                  <a:lnTo>
                    <a:pt x="1968627" y="0"/>
                  </a:lnTo>
                </a:path>
                <a:path w="11446510" h="2539">
                  <a:moveTo>
                    <a:pt x="2037969" y="0"/>
                  </a:moveTo>
                  <a:lnTo>
                    <a:pt x="2540889" y="0"/>
                  </a:lnTo>
                </a:path>
                <a:path w="11446510" h="2539">
                  <a:moveTo>
                    <a:pt x="2610231" y="0"/>
                  </a:moveTo>
                  <a:lnTo>
                    <a:pt x="2716911" y="0"/>
                  </a:lnTo>
                </a:path>
                <a:path w="11446510" h="2539">
                  <a:moveTo>
                    <a:pt x="2785491" y="0"/>
                  </a:moveTo>
                  <a:lnTo>
                    <a:pt x="3509391" y="0"/>
                  </a:lnTo>
                </a:path>
                <a:path w="11446510" h="2539">
                  <a:moveTo>
                    <a:pt x="3578732" y="0"/>
                  </a:moveTo>
                  <a:lnTo>
                    <a:pt x="3597782" y="0"/>
                  </a:lnTo>
                </a:path>
                <a:path w="11446510" h="2539">
                  <a:moveTo>
                    <a:pt x="3666362" y="0"/>
                  </a:moveTo>
                  <a:lnTo>
                    <a:pt x="3685413" y="0"/>
                  </a:lnTo>
                </a:path>
                <a:path w="11446510" h="2539">
                  <a:moveTo>
                    <a:pt x="3754754" y="0"/>
                  </a:moveTo>
                  <a:lnTo>
                    <a:pt x="3773042" y="0"/>
                  </a:lnTo>
                </a:path>
                <a:path w="11446510" h="2539">
                  <a:moveTo>
                    <a:pt x="3842384" y="0"/>
                  </a:moveTo>
                  <a:lnTo>
                    <a:pt x="3861434" y="0"/>
                  </a:lnTo>
                </a:path>
                <a:path w="11446510" h="2539">
                  <a:moveTo>
                    <a:pt x="3930014" y="0"/>
                  </a:moveTo>
                  <a:lnTo>
                    <a:pt x="4081653" y="0"/>
                  </a:lnTo>
                </a:path>
                <a:path w="11446510" h="2539">
                  <a:moveTo>
                    <a:pt x="4150994" y="0"/>
                  </a:moveTo>
                  <a:lnTo>
                    <a:pt x="4170044" y="0"/>
                  </a:lnTo>
                </a:path>
                <a:path w="11446510" h="2539">
                  <a:moveTo>
                    <a:pt x="4238624" y="0"/>
                  </a:moveTo>
                  <a:lnTo>
                    <a:pt x="4257675" y="0"/>
                  </a:lnTo>
                </a:path>
                <a:path w="11446510" h="2539">
                  <a:moveTo>
                    <a:pt x="4327017" y="0"/>
                  </a:moveTo>
                  <a:lnTo>
                    <a:pt x="4345305" y="0"/>
                  </a:lnTo>
                </a:path>
                <a:path w="11446510" h="2539">
                  <a:moveTo>
                    <a:pt x="4414646" y="0"/>
                  </a:moveTo>
                  <a:lnTo>
                    <a:pt x="4433696" y="0"/>
                  </a:lnTo>
                </a:path>
                <a:path w="11446510" h="2539">
                  <a:moveTo>
                    <a:pt x="4502276" y="0"/>
                  </a:moveTo>
                  <a:lnTo>
                    <a:pt x="4653915" y="0"/>
                  </a:lnTo>
                </a:path>
                <a:path w="11446510" h="2539">
                  <a:moveTo>
                    <a:pt x="4723257" y="0"/>
                  </a:moveTo>
                  <a:lnTo>
                    <a:pt x="4742307" y="0"/>
                  </a:lnTo>
                </a:path>
                <a:path w="11446510" h="2539">
                  <a:moveTo>
                    <a:pt x="4811648" y="0"/>
                  </a:moveTo>
                  <a:lnTo>
                    <a:pt x="4829937" y="0"/>
                  </a:lnTo>
                </a:path>
                <a:path w="11446510" h="2539">
                  <a:moveTo>
                    <a:pt x="4899279" y="0"/>
                  </a:moveTo>
                  <a:lnTo>
                    <a:pt x="4917567" y="0"/>
                  </a:lnTo>
                </a:path>
                <a:path w="11446510" h="2539">
                  <a:moveTo>
                    <a:pt x="4986908" y="0"/>
                  </a:moveTo>
                  <a:lnTo>
                    <a:pt x="5005958" y="0"/>
                  </a:lnTo>
                </a:path>
                <a:path w="11446510" h="2539">
                  <a:moveTo>
                    <a:pt x="5075300" y="0"/>
                  </a:moveTo>
                  <a:lnTo>
                    <a:pt x="5402199" y="0"/>
                  </a:lnTo>
                </a:path>
                <a:path w="11446510" h="2539">
                  <a:moveTo>
                    <a:pt x="5471541" y="0"/>
                  </a:moveTo>
                  <a:lnTo>
                    <a:pt x="5974461" y="0"/>
                  </a:lnTo>
                </a:path>
                <a:path w="11446510" h="2539">
                  <a:moveTo>
                    <a:pt x="6043803" y="0"/>
                  </a:moveTo>
                  <a:lnTo>
                    <a:pt x="6062091" y="0"/>
                  </a:lnTo>
                </a:path>
                <a:path w="11446510" h="2539">
                  <a:moveTo>
                    <a:pt x="6131433" y="0"/>
                  </a:moveTo>
                  <a:lnTo>
                    <a:pt x="6150483" y="0"/>
                  </a:lnTo>
                </a:path>
                <a:path w="11446510" h="2539">
                  <a:moveTo>
                    <a:pt x="6219825" y="0"/>
                  </a:moveTo>
                  <a:lnTo>
                    <a:pt x="6635115" y="0"/>
                  </a:lnTo>
                </a:path>
                <a:path w="11446510" h="2539">
                  <a:moveTo>
                    <a:pt x="6703695" y="0"/>
                  </a:moveTo>
                  <a:lnTo>
                    <a:pt x="6943725" y="0"/>
                  </a:lnTo>
                </a:path>
                <a:path w="11446510" h="2539">
                  <a:moveTo>
                    <a:pt x="7012305" y="0"/>
                  </a:moveTo>
                  <a:lnTo>
                    <a:pt x="7031355" y="0"/>
                  </a:lnTo>
                </a:path>
                <a:path w="11446510" h="2539">
                  <a:moveTo>
                    <a:pt x="7100697" y="0"/>
                  </a:moveTo>
                  <a:lnTo>
                    <a:pt x="7207377" y="0"/>
                  </a:lnTo>
                </a:path>
                <a:path w="11446510" h="2539">
                  <a:moveTo>
                    <a:pt x="7275957" y="0"/>
                  </a:moveTo>
                  <a:lnTo>
                    <a:pt x="7295007" y="0"/>
                  </a:lnTo>
                </a:path>
                <a:path w="11446510" h="2539">
                  <a:moveTo>
                    <a:pt x="7364349" y="0"/>
                  </a:moveTo>
                  <a:lnTo>
                    <a:pt x="7515987" y="0"/>
                  </a:lnTo>
                </a:path>
                <a:path w="11446510" h="2539">
                  <a:moveTo>
                    <a:pt x="7584567" y="0"/>
                  </a:moveTo>
                  <a:lnTo>
                    <a:pt x="7603617" y="0"/>
                  </a:lnTo>
                </a:path>
                <a:path w="11446510" h="2539">
                  <a:moveTo>
                    <a:pt x="7672959" y="0"/>
                  </a:moveTo>
                  <a:lnTo>
                    <a:pt x="7691247" y="0"/>
                  </a:lnTo>
                </a:path>
                <a:path w="11446510" h="2539">
                  <a:moveTo>
                    <a:pt x="7760589" y="0"/>
                  </a:moveTo>
                  <a:lnTo>
                    <a:pt x="7779639" y="0"/>
                  </a:lnTo>
                </a:path>
                <a:path w="11446510" h="2539">
                  <a:moveTo>
                    <a:pt x="7848219" y="0"/>
                  </a:moveTo>
                  <a:lnTo>
                    <a:pt x="7867269" y="0"/>
                  </a:lnTo>
                </a:path>
                <a:path w="11446510" h="2539">
                  <a:moveTo>
                    <a:pt x="7936611" y="0"/>
                  </a:moveTo>
                  <a:lnTo>
                    <a:pt x="8088249" y="0"/>
                  </a:lnTo>
                </a:path>
                <a:path w="11446510" h="2539">
                  <a:moveTo>
                    <a:pt x="8156829" y="0"/>
                  </a:moveTo>
                  <a:lnTo>
                    <a:pt x="8175879" y="0"/>
                  </a:lnTo>
                </a:path>
                <a:path w="11446510" h="2539">
                  <a:moveTo>
                    <a:pt x="8245221" y="0"/>
                  </a:moveTo>
                  <a:lnTo>
                    <a:pt x="8263509" y="0"/>
                  </a:lnTo>
                </a:path>
                <a:path w="11446510" h="2539">
                  <a:moveTo>
                    <a:pt x="8332851" y="0"/>
                  </a:moveTo>
                  <a:lnTo>
                    <a:pt x="8351901" y="0"/>
                  </a:lnTo>
                </a:path>
                <a:path w="11446510" h="2539">
                  <a:moveTo>
                    <a:pt x="8420481" y="0"/>
                  </a:moveTo>
                  <a:lnTo>
                    <a:pt x="8439531" y="0"/>
                  </a:lnTo>
                </a:path>
                <a:path w="11446510" h="2539">
                  <a:moveTo>
                    <a:pt x="8508873" y="0"/>
                  </a:moveTo>
                  <a:lnTo>
                    <a:pt x="8660511" y="0"/>
                  </a:lnTo>
                </a:path>
                <a:path w="11446510" h="2539">
                  <a:moveTo>
                    <a:pt x="8729853" y="0"/>
                  </a:moveTo>
                  <a:lnTo>
                    <a:pt x="8748141" y="0"/>
                  </a:lnTo>
                </a:path>
                <a:path w="11446510" h="2539">
                  <a:moveTo>
                    <a:pt x="8817483" y="0"/>
                  </a:moveTo>
                  <a:lnTo>
                    <a:pt x="8835771" y="0"/>
                  </a:lnTo>
                </a:path>
                <a:path w="11446510" h="2539">
                  <a:moveTo>
                    <a:pt x="8905113" y="0"/>
                  </a:moveTo>
                  <a:lnTo>
                    <a:pt x="8924163" y="0"/>
                  </a:lnTo>
                </a:path>
                <a:path w="11446510" h="2539">
                  <a:moveTo>
                    <a:pt x="8993505" y="0"/>
                  </a:moveTo>
                  <a:lnTo>
                    <a:pt x="9011793" y="0"/>
                  </a:lnTo>
                </a:path>
                <a:path w="11446510" h="2539">
                  <a:moveTo>
                    <a:pt x="9081135" y="0"/>
                  </a:moveTo>
                  <a:lnTo>
                    <a:pt x="9232773" y="0"/>
                  </a:lnTo>
                </a:path>
                <a:path w="11446510" h="2539">
                  <a:moveTo>
                    <a:pt x="9302115" y="0"/>
                  </a:moveTo>
                  <a:lnTo>
                    <a:pt x="9320403" y="0"/>
                  </a:lnTo>
                </a:path>
                <a:path w="11446510" h="2539">
                  <a:moveTo>
                    <a:pt x="9389745" y="0"/>
                  </a:moveTo>
                  <a:lnTo>
                    <a:pt x="9408033" y="0"/>
                  </a:lnTo>
                </a:path>
                <a:path w="11446510" h="2539">
                  <a:moveTo>
                    <a:pt x="9477375" y="0"/>
                  </a:moveTo>
                  <a:lnTo>
                    <a:pt x="9496425" y="0"/>
                  </a:lnTo>
                </a:path>
                <a:path w="11446510" h="2539">
                  <a:moveTo>
                    <a:pt x="9565767" y="0"/>
                  </a:moveTo>
                  <a:lnTo>
                    <a:pt x="9584055" y="0"/>
                  </a:lnTo>
                </a:path>
                <a:path w="11446510" h="2539">
                  <a:moveTo>
                    <a:pt x="9653397" y="0"/>
                  </a:moveTo>
                  <a:lnTo>
                    <a:pt x="9805035" y="0"/>
                  </a:lnTo>
                </a:path>
                <a:path w="11446510" h="2539">
                  <a:moveTo>
                    <a:pt x="9874377" y="0"/>
                  </a:moveTo>
                  <a:lnTo>
                    <a:pt x="9892665" y="0"/>
                  </a:lnTo>
                </a:path>
                <a:path w="11446510" h="2539">
                  <a:moveTo>
                    <a:pt x="9962007" y="0"/>
                  </a:moveTo>
                  <a:lnTo>
                    <a:pt x="9980295" y="0"/>
                  </a:lnTo>
                </a:path>
                <a:path w="11446510" h="2539">
                  <a:moveTo>
                    <a:pt x="10049637" y="0"/>
                  </a:moveTo>
                  <a:lnTo>
                    <a:pt x="10068687" y="0"/>
                  </a:lnTo>
                </a:path>
                <a:path w="11446510" h="2539">
                  <a:moveTo>
                    <a:pt x="10138029" y="0"/>
                  </a:moveTo>
                  <a:lnTo>
                    <a:pt x="10156317" y="0"/>
                  </a:lnTo>
                </a:path>
                <a:path w="11446510" h="2539">
                  <a:moveTo>
                    <a:pt x="10225659" y="0"/>
                  </a:moveTo>
                  <a:lnTo>
                    <a:pt x="10377297" y="0"/>
                  </a:lnTo>
                </a:path>
                <a:path w="11446510" h="2539">
                  <a:moveTo>
                    <a:pt x="10446639" y="0"/>
                  </a:moveTo>
                  <a:lnTo>
                    <a:pt x="10464927" y="0"/>
                  </a:lnTo>
                </a:path>
                <a:path w="11446510" h="2539">
                  <a:moveTo>
                    <a:pt x="10534269" y="0"/>
                  </a:moveTo>
                  <a:lnTo>
                    <a:pt x="10553319" y="0"/>
                  </a:lnTo>
                </a:path>
                <a:path w="11446510" h="2539">
                  <a:moveTo>
                    <a:pt x="10621899" y="0"/>
                  </a:moveTo>
                  <a:lnTo>
                    <a:pt x="10640949" y="0"/>
                  </a:lnTo>
                </a:path>
                <a:path w="11446510" h="2539">
                  <a:moveTo>
                    <a:pt x="10710291" y="0"/>
                  </a:moveTo>
                  <a:lnTo>
                    <a:pt x="10728579" y="0"/>
                  </a:lnTo>
                </a:path>
                <a:path w="11446510" h="2539">
                  <a:moveTo>
                    <a:pt x="10797921" y="0"/>
                  </a:moveTo>
                  <a:lnTo>
                    <a:pt x="10949559" y="0"/>
                  </a:lnTo>
                </a:path>
                <a:path w="11446510" h="2539">
                  <a:moveTo>
                    <a:pt x="11018901" y="0"/>
                  </a:moveTo>
                  <a:lnTo>
                    <a:pt x="11037189" y="0"/>
                  </a:lnTo>
                </a:path>
                <a:path w="11446510" h="2539">
                  <a:moveTo>
                    <a:pt x="11106531" y="0"/>
                  </a:moveTo>
                  <a:lnTo>
                    <a:pt x="11125581" y="0"/>
                  </a:lnTo>
                </a:path>
                <a:path w="11446510" h="2539">
                  <a:moveTo>
                    <a:pt x="11194161" y="0"/>
                  </a:moveTo>
                  <a:lnTo>
                    <a:pt x="11213211" y="0"/>
                  </a:lnTo>
                </a:path>
                <a:path w="11446510" h="2539">
                  <a:moveTo>
                    <a:pt x="11282553" y="0"/>
                  </a:moveTo>
                  <a:lnTo>
                    <a:pt x="11300841" y="0"/>
                  </a:lnTo>
                </a:path>
                <a:path w="11446510" h="2539">
                  <a:moveTo>
                    <a:pt x="11370183" y="0"/>
                  </a:moveTo>
                  <a:lnTo>
                    <a:pt x="11446002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511302" y="3578351"/>
              <a:ext cx="2358390" cy="462915"/>
            </a:xfrm>
            <a:custGeom>
              <a:avLst/>
              <a:gdLst/>
              <a:ahLst/>
              <a:cxnLst/>
              <a:rect l="l" t="t" r="r" b="b"/>
              <a:pathLst>
                <a:path w="2358390" h="462914">
                  <a:moveTo>
                    <a:pt x="69342" y="109728"/>
                  </a:moveTo>
                  <a:lnTo>
                    <a:pt x="0" y="109728"/>
                  </a:lnTo>
                  <a:lnTo>
                    <a:pt x="0" y="118872"/>
                  </a:lnTo>
                  <a:lnTo>
                    <a:pt x="69342" y="118872"/>
                  </a:lnTo>
                  <a:lnTo>
                    <a:pt x="69342" y="109728"/>
                  </a:lnTo>
                  <a:close/>
                </a:path>
                <a:path w="2358390" h="462914">
                  <a:moveTo>
                    <a:pt x="641591" y="0"/>
                  </a:moveTo>
                  <a:lnTo>
                    <a:pt x="572262" y="0"/>
                  </a:lnTo>
                  <a:lnTo>
                    <a:pt x="572262" y="109728"/>
                  </a:lnTo>
                  <a:lnTo>
                    <a:pt x="641591" y="109728"/>
                  </a:lnTo>
                  <a:lnTo>
                    <a:pt x="641591" y="0"/>
                  </a:lnTo>
                  <a:close/>
                </a:path>
                <a:path w="2358390" h="462914">
                  <a:moveTo>
                    <a:pt x="1213866" y="109728"/>
                  </a:moveTo>
                  <a:lnTo>
                    <a:pt x="1144524" y="109728"/>
                  </a:lnTo>
                  <a:lnTo>
                    <a:pt x="1144524" y="210312"/>
                  </a:lnTo>
                  <a:lnTo>
                    <a:pt x="1213866" y="210312"/>
                  </a:lnTo>
                  <a:lnTo>
                    <a:pt x="1213866" y="109728"/>
                  </a:lnTo>
                  <a:close/>
                </a:path>
                <a:path w="2358390" h="462914">
                  <a:moveTo>
                    <a:pt x="1786128" y="109728"/>
                  </a:moveTo>
                  <a:lnTo>
                    <a:pt x="1716786" y="109728"/>
                  </a:lnTo>
                  <a:lnTo>
                    <a:pt x="1716786" y="462534"/>
                  </a:lnTo>
                  <a:lnTo>
                    <a:pt x="1786128" y="462534"/>
                  </a:lnTo>
                  <a:lnTo>
                    <a:pt x="1786128" y="109728"/>
                  </a:lnTo>
                  <a:close/>
                </a:path>
                <a:path w="2358390" h="462914">
                  <a:moveTo>
                    <a:pt x="2358390" y="109728"/>
                  </a:moveTo>
                  <a:lnTo>
                    <a:pt x="2289048" y="109728"/>
                  </a:lnTo>
                  <a:lnTo>
                    <a:pt x="2289048" y="420624"/>
                  </a:lnTo>
                  <a:lnTo>
                    <a:pt x="2358390" y="420624"/>
                  </a:lnTo>
                  <a:lnTo>
                    <a:pt x="2358390" y="109728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2957322" y="4033646"/>
              <a:ext cx="8924290" cy="3810"/>
            </a:xfrm>
            <a:custGeom>
              <a:avLst/>
              <a:gdLst/>
              <a:ahLst/>
              <a:cxnLst/>
              <a:rect l="l" t="t" r="r" b="b"/>
              <a:pathLst>
                <a:path w="8924290" h="3810">
                  <a:moveTo>
                    <a:pt x="0" y="0"/>
                  </a:moveTo>
                  <a:lnTo>
                    <a:pt x="8924163" y="0"/>
                  </a:lnTo>
                </a:path>
                <a:path w="8924290" h="3810">
                  <a:moveTo>
                    <a:pt x="0" y="3809"/>
                  </a:moveTo>
                  <a:lnTo>
                    <a:pt x="8924163" y="3809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2957322" y="4042028"/>
              <a:ext cx="8924290" cy="0"/>
            </a:xfrm>
            <a:custGeom>
              <a:avLst/>
              <a:gdLst/>
              <a:ahLst/>
              <a:cxnLst/>
              <a:rect l="l" t="t" r="r" b="b"/>
              <a:pathLst>
                <a:path w="8924290">
                  <a:moveTo>
                    <a:pt x="0" y="0"/>
                  </a:moveTo>
                  <a:lnTo>
                    <a:pt x="8924163" y="0"/>
                  </a:lnTo>
                </a:path>
              </a:pathLst>
            </a:custGeom>
            <a:ln w="7620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3372612" y="3688079"/>
              <a:ext cx="69850" cy="339090"/>
            </a:xfrm>
            <a:custGeom>
              <a:avLst/>
              <a:gdLst/>
              <a:ahLst/>
              <a:cxnLst/>
              <a:rect l="l" t="t" r="r" b="b"/>
              <a:pathLst>
                <a:path w="69850" h="339089">
                  <a:moveTo>
                    <a:pt x="69341" y="0"/>
                  </a:moveTo>
                  <a:lnTo>
                    <a:pt x="0" y="0"/>
                  </a:lnTo>
                  <a:lnTo>
                    <a:pt x="0" y="339090"/>
                  </a:lnTo>
                  <a:lnTo>
                    <a:pt x="69341" y="339090"/>
                  </a:lnTo>
                  <a:lnTo>
                    <a:pt x="69341" y="0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435483" y="3337178"/>
              <a:ext cx="3597910" cy="0"/>
            </a:xfrm>
            <a:custGeom>
              <a:avLst/>
              <a:gdLst/>
              <a:ahLst/>
              <a:cxnLst/>
              <a:rect l="l" t="t" r="r" b="b"/>
              <a:pathLst>
                <a:path w="3597910">
                  <a:moveTo>
                    <a:pt x="0" y="0"/>
                  </a:moveTo>
                  <a:lnTo>
                    <a:pt x="3509391" y="0"/>
                  </a:lnTo>
                </a:path>
                <a:path w="3597910">
                  <a:moveTo>
                    <a:pt x="3578732" y="0"/>
                  </a:moveTo>
                  <a:lnTo>
                    <a:pt x="3597782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3944873" y="3248405"/>
              <a:ext cx="69850" cy="440055"/>
            </a:xfrm>
            <a:custGeom>
              <a:avLst/>
              <a:gdLst/>
              <a:ahLst/>
              <a:cxnLst/>
              <a:rect l="l" t="t" r="r" b="b"/>
              <a:pathLst>
                <a:path w="69850" h="440054">
                  <a:moveTo>
                    <a:pt x="69341" y="0"/>
                  </a:moveTo>
                  <a:lnTo>
                    <a:pt x="0" y="0"/>
                  </a:lnTo>
                  <a:lnTo>
                    <a:pt x="0" y="439674"/>
                  </a:lnTo>
                  <a:lnTo>
                    <a:pt x="69341" y="439674"/>
                  </a:lnTo>
                  <a:lnTo>
                    <a:pt x="69341" y="0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4365498" y="3337178"/>
              <a:ext cx="240029" cy="0"/>
            </a:xfrm>
            <a:custGeom>
              <a:avLst/>
              <a:gdLst/>
              <a:ahLst/>
              <a:cxnLst/>
              <a:rect l="l" t="t" r="r" b="b"/>
              <a:pathLst>
                <a:path w="240029">
                  <a:moveTo>
                    <a:pt x="0" y="0"/>
                  </a:moveTo>
                  <a:lnTo>
                    <a:pt x="151638" y="0"/>
                  </a:lnTo>
                </a:path>
                <a:path w="240029">
                  <a:moveTo>
                    <a:pt x="220980" y="0"/>
                  </a:moveTo>
                  <a:lnTo>
                    <a:pt x="24003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4365498" y="2985515"/>
              <a:ext cx="240029" cy="5080"/>
            </a:xfrm>
            <a:custGeom>
              <a:avLst/>
              <a:gdLst/>
              <a:ahLst/>
              <a:cxnLst/>
              <a:rect l="l" t="t" r="r" b="b"/>
              <a:pathLst>
                <a:path w="240029" h="5080">
                  <a:moveTo>
                    <a:pt x="0" y="4952"/>
                  </a:moveTo>
                  <a:lnTo>
                    <a:pt x="240030" y="4952"/>
                  </a:lnTo>
                </a:path>
                <a:path w="240029" h="5080">
                  <a:moveTo>
                    <a:pt x="0" y="0"/>
                  </a:moveTo>
                  <a:lnTo>
                    <a:pt x="240030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4517136" y="2989325"/>
              <a:ext cx="69850" cy="699135"/>
            </a:xfrm>
            <a:custGeom>
              <a:avLst/>
              <a:gdLst/>
              <a:ahLst/>
              <a:cxnLst/>
              <a:rect l="l" t="t" r="r" b="b"/>
              <a:pathLst>
                <a:path w="69850" h="699135">
                  <a:moveTo>
                    <a:pt x="69341" y="0"/>
                  </a:moveTo>
                  <a:lnTo>
                    <a:pt x="0" y="0"/>
                  </a:lnTo>
                  <a:lnTo>
                    <a:pt x="0" y="698754"/>
                  </a:lnTo>
                  <a:lnTo>
                    <a:pt x="69341" y="698754"/>
                  </a:lnTo>
                  <a:lnTo>
                    <a:pt x="69341" y="0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4937760" y="3337178"/>
              <a:ext cx="240029" cy="0"/>
            </a:xfrm>
            <a:custGeom>
              <a:avLst/>
              <a:gdLst/>
              <a:ahLst/>
              <a:cxnLst/>
              <a:rect l="l" t="t" r="r" b="b"/>
              <a:pathLst>
                <a:path w="240029">
                  <a:moveTo>
                    <a:pt x="0" y="0"/>
                  </a:moveTo>
                  <a:lnTo>
                    <a:pt x="151638" y="0"/>
                  </a:lnTo>
                </a:path>
                <a:path w="240029">
                  <a:moveTo>
                    <a:pt x="220980" y="0"/>
                  </a:moveTo>
                  <a:lnTo>
                    <a:pt x="24003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5089398" y="3304793"/>
              <a:ext cx="2358390" cy="729615"/>
            </a:xfrm>
            <a:custGeom>
              <a:avLst/>
              <a:gdLst/>
              <a:ahLst/>
              <a:cxnLst/>
              <a:rect l="l" t="t" r="r" b="b"/>
              <a:pathLst>
                <a:path w="2358390" h="729614">
                  <a:moveTo>
                    <a:pt x="69342" y="0"/>
                  </a:moveTo>
                  <a:lnTo>
                    <a:pt x="0" y="0"/>
                  </a:lnTo>
                  <a:lnTo>
                    <a:pt x="0" y="383298"/>
                  </a:lnTo>
                  <a:lnTo>
                    <a:pt x="69342" y="383298"/>
                  </a:lnTo>
                  <a:lnTo>
                    <a:pt x="69342" y="0"/>
                  </a:lnTo>
                  <a:close/>
                </a:path>
                <a:path w="2358390" h="729614">
                  <a:moveTo>
                    <a:pt x="641604" y="383286"/>
                  </a:moveTo>
                  <a:lnTo>
                    <a:pt x="572262" y="383286"/>
                  </a:lnTo>
                  <a:lnTo>
                    <a:pt x="572262" y="729234"/>
                  </a:lnTo>
                  <a:lnTo>
                    <a:pt x="641604" y="729234"/>
                  </a:lnTo>
                  <a:lnTo>
                    <a:pt x="641604" y="383286"/>
                  </a:lnTo>
                  <a:close/>
                </a:path>
                <a:path w="2358390" h="729614">
                  <a:moveTo>
                    <a:pt x="1213866" y="383286"/>
                  </a:moveTo>
                  <a:lnTo>
                    <a:pt x="1144524" y="383286"/>
                  </a:lnTo>
                  <a:lnTo>
                    <a:pt x="1144524" y="497586"/>
                  </a:lnTo>
                  <a:lnTo>
                    <a:pt x="1213866" y="497586"/>
                  </a:lnTo>
                  <a:lnTo>
                    <a:pt x="1213866" y="383286"/>
                  </a:lnTo>
                  <a:close/>
                </a:path>
                <a:path w="2358390" h="729614">
                  <a:moveTo>
                    <a:pt x="1786128" y="383286"/>
                  </a:moveTo>
                  <a:lnTo>
                    <a:pt x="1717548" y="383286"/>
                  </a:lnTo>
                  <a:lnTo>
                    <a:pt x="1717548" y="602742"/>
                  </a:lnTo>
                  <a:lnTo>
                    <a:pt x="1786128" y="602742"/>
                  </a:lnTo>
                  <a:lnTo>
                    <a:pt x="1786128" y="383286"/>
                  </a:lnTo>
                  <a:close/>
                </a:path>
                <a:path w="2358390" h="729614">
                  <a:moveTo>
                    <a:pt x="2358377" y="259080"/>
                  </a:moveTo>
                  <a:lnTo>
                    <a:pt x="2289810" y="259080"/>
                  </a:lnTo>
                  <a:lnTo>
                    <a:pt x="2289810" y="383286"/>
                  </a:lnTo>
                  <a:lnTo>
                    <a:pt x="2358377" y="383286"/>
                  </a:lnTo>
                  <a:lnTo>
                    <a:pt x="2358377" y="259080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7799831" y="3337178"/>
              <a:ext cx="327025" cy="0"/>
            </a:xfrm>
            <a:custGeom>
              <a:avLst/>
              <a:gdLst/>
              <a:ahLst/>
              <a:cxnLst/>
              <a:rect l="l" t="t" r="r" b="b"/>
              <a:pathLst>
                <a:path w="327025">
                  <a:moveTo>
                    <a:pt x="0" y="0"/>
                  </a:moveTo>
                  <a:lnTo>
                    <a:pt x="151637" y="0"/>
                  </a:lnTo>
                </a:path>
                <a:path w="327025">
                  <a:moveTo>
                    <a:pt x="220217" y="0"/>
                  </a:moveTo>
                  <a:lnTo>
                    <a:pt x="32689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7951469" y="3283457"/>
              <a:ext cx="68580" cy="405130"/>
            </a:xfrm>
            <a:custGeom>
              <a:avLst/>
              <a:gdLst/>
              <a:ahLst/>
              <a:cxnLst/>
              <a:rect l="l" t="t" r="r" b="b"/>
              <a:pathLst>
                <a:path w="68579" h="405129">
                  <a:moveTo>
                    <a:pt x="68579" y="0"/>
                  </a:moveTo>
                  <a:lnTo>
                    <a:pt x="0" y="0"/>
                  </a:lnTo>
                  <a:lnTo>
                    <a:pt x="0" y="404622"/>
                  </a:lnTo>
                  <a:lnTo>
                    <a:pt x="68579" y="404622"/>
                  </a:lnTo>
                  <a:lnTo>
                    <a:pt x="68579" y="0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8372093" y="3337178"/>
              <a:ext cx="239395" cy="0"/>
            </a:xfrm>
            <a:custGeom>
              <a:avLst/>
              <a:gdLst/>
              <a:ahLst/>
              <a:cxnLst/>
              <a:rect l="l" t="t" r="r" b="b"/>
              <a:pathLst>
                <a:path w="239395">
                  <a:moveTo>
                    <a:pt x="0" y="0"/>
                  </a:moveTo>
                  <a:lnTo>
                    <a:pt x="151637" y="0"/>
                  </a:lnTo>
                </a:path>
                <a:path w="239395">
                  <a:moveTo>
                    <a:pt x="220217" y="0"/>
                  </a:moveTo>
                  <a:lnTo>
                    <a:pt x="23926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8523731" y="3248405"/>
              <a:ext cx="68580" cy="440055"/>
            </a:xfrm>
            <a:custGeom>
              <a:avLst/>
              <a:gdLst/>
              <a:ahLst/>
              <a:cxnLst/>
              <a:rect l="l" t="t" r="r" b="b"/>
              <a:pathLst>
                <a:path w="68579" h="440054">
                  <a:moveTo>
                    <a:pt x="68579" y="0"/>
                  </a:moveTo>
                  <a:lnTo>
                    <a:pt x="0" y="0"/>
                  </a:lnTo>
                  <a:lnTo>
                    <a:pt x="0" y="439674"/>
                  </a:lnTo>
                  <a:lnTo>
                    <a:pt x="68579" y="439674"/>
                  </a:lnTo>
                  <a:lnTo>
                    <a:pt x="68579" y="0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8944355" y="3336035"/>
              <a:ext cx="151765" cy="5080"/>
            </a:xfrm>
            <a:custGeom>
              <a:avLst/>
              <a:gdLst/>
              <a:ahLst/>
              <a:cxnLst/>
              <a:rect l="l" t="t" r="r" b="b"/>
              <a:pathLst>
                <a:path w="151765" h="5079">
                  <a:moveTo>
                    <a:pt x="0" y="4952"/>
                  </a:moveTo>
                  <a:lnTo>
                    <a:pt x="151637" y="4952"/>
                  </a:lnTo>
                </a:path>
                <a:path w="151765" h="5079">
                  <a:moveTo>
                    <a:pt x="0" y="0"/>
                  </a:moveTo>
                  <a:lnTo>
                    <a:pt x="151637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9165336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5">
                  <a:moveTo>
                    <a:pt x="0" y="0"/>
                  </a:moveTo>
                  <a:lnTo>
                    <a:pt x="1828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9095993" y="3143249"/>
              <a:ext cx="69850" cy="544830"/>
            </a:xfrm>
            <a:custGeom>
              <a:avLst/>
              <a:gdLst/>
              <a:ahLst/>
              <a:cxnLst/>
              <a:rect l="l" t="t" r="r" b="b"/>
              <a:pathLst>
                <a:path w="69850" h="544829">
                  <a:moveTo>
                    <a:pt x="69342" y="0"/>
                  </a:moveTo>
                  <a:lnTo>
                    <a:pt x="0" y="0"/>
                  </a:lnTo>
                  <a:lnTo>
                    <a:pt x="0" y="544830"/>
                  </a:lnTo>
                  <a:lnTo>
                    <a:pt x="69342" y="544830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4"/>
            <p:cNvSpPr/>
            <p:nvPr/>
          </p:nvSpPr>
          <p:spPr>
            <a:xfrm>
              <a:off x="9516617" y="3337178"/>
              <a:ext cx="239395" cy="0"/>
            </a:xfrm>
            <a:custGeom>
              <a:avLst/>
              <a:gdLst/>
              <a:ahLst/>
              <a:cxnLst/>
              <a:rect l="l" t="t" r="r" b="b"/>
              <a:pathLst>
                <a:path w="239395">
                  <a:moveTo>
                    <a:pt x="0" y="0"/>
                  </a:moveTo>
                  <a:lnTo>
                    <a:pt x="151637" y="0"/>
                  </a:lnTo>
                </a:path>
                <a:path w="239395">
                  <a:moveTo>
                    <a:pt x="220979" y="0"/>
                  </a:moveTo>
                  <a:lnTo>
                    <a:pt x="23926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9668255" y="3283457"/>
              <a:ext cx="69850" cy="405130"/>
            </a:xfrm>
            <a:custGeom>
              <a:avLst/>
              <a:gdLst/>
              <a:ahLst/>
              <a:cxnLst/>
              <a:rect l="l" t="t" r="r" b="b"/>
              <a:pathLst>
                <a:path w="69850" h="405129">
                  <a:moveTo>
                    <a:pt x="69342" y="0"/>
                  </a:moveTo>
                  <a:lnTo>
                    <a:pt x="0" y="0"/>
                  </a:lnTo>
                  <a:lnTo>
                    <a:pt x="0" y="404622"/>
                  </a:lnTo>
                  <a:lnTo>
                    <a:pt x="69342" y="404622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10088879" y="3337178"/>
              <a:ext cx="239395" cy="0"/>
            </a:xfrm>
            <a:custGeom>
              <a:avLst/>
              <a:gdLst/>
              <a:ahLst/>
              <a:cxnLst/>
              <a:rect l="l" t="t" r="r" b="b"/>
              <a:pathLst>
                <a:path w="239395">
                  <a:moveTo>
                    <a:pt x="0" y="0"/>
                  </a:moveTo>
                  <a:lnTo>
                    <a:pt x="151637" y="0"/>
                  </a:lnTo>
                </a:path>
                <a:path w="239395">
                  <a:moveTo>
                    <a:pt x="220979" y="0"/>
                  </a:moveTo>
                  <a:lnTo>
                    <a:pt x="23926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10240518" y="3178301"/>
              <a:ext cx="641985" cy="509905"/>
            </a:xfrm>
            <a:custGeom>
              <a:avLst/>
              <a:gdLst/>
              <a:ahLst/>
              <a:cxnLst/>
              <a:rect l="l" t="t" r="r" b="b"/>
              <a:pathLst>
                <a:path w="641984" h="509904">
                  <a:moveTo>
                    <a:pt x="69342" y="0"/>
                  </a:moveTo>
                  <a:lnTo>
                    <a:pt x="0" y="0"/>
                  </a:lnTo>
                  <a:lnTo>
                    <a:pt x="0" y="509778"/>
                  </a:lnTo>
                  <a:lnTo>
                    <a:pt x="69342" y="509778"/>
                  </a:lnTo>
                  <a:lnTo>
                    <a:pt x="69342" y="0"/>
                  </a:lnTo>
                  <a:close/>
                </a:path>
                <a:path w="641984" h="509904">
                  <a:moveTo>
                    <a:pt x="641604" y="236982"/>
                  </a:moveTo>
                  <a:lnTo>
                    <a:pt x="572262" y="236982"/>
                  </a:lnTo>
                  <a:lnTo>
                    <a:pt x="572262" y="509778"/>
                  </a:lnTo>
                  <a:lnTo>
                    <a:pt x="641604" y="509778"/>
                  </a:lnTo>
                  <a:lnTo>
                    <a:pt x="641604" y="236982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11233403" y="3337178"/>
              <a:ext cx="239395" cy="0"/>
            </a:xfrm>
            <a:custGeom>
              <a:avLst/>
              <a:gdLst/>
              <a:ahLst/>
              <a:cxnLst/>
              <a:rect l="l" t="t" r="r" b="b"/>
              <a:pathLst>
                <a:path w="239395">
                  <a:moveTo>
                    <a:pt x="0" y="0"/>
                  </a:moveTo>
                  <a:lnTo>
                    <a:pt x="151638" y="0"/>
                  </a:lnTo>
                </a:path>
                <a:path w="239395">
                  <a:moveTo>
                    <a:pt x="220980" y="0"/>
                  </a:moveTo>
                  <a:lnTo>
                    <a:pt x="239268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11385041" y="3249167"/>
              <a:ext cx="69850" cy="439420"/>
            </a:xfrm>
            <a:custGeom>
              <a:avLst/>
              <a:gdLst/>
              <a:ahLst/>
              <a:cxnLst/>
              <a:rect l="l" t="t" r="r" b="b"/>
              <a:pathLst>
                <a:path w="69850" h="439420">
                  <a:moveTo>
                    <a:pt x="69342" y="0"/>
                  </a:moveTo>
                  <a:lnTo>
                    <a:pt x="0" y="0"/>
                  </a:lnTo>
                  <a:lnTo>
                    <a:pt x="0" y="438912"/>
                  </a:lnTo>
                  <a:lnTo>
                    <a:pt x="69342" y="438912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1D9A7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598932" y="3643883"/>
              <a:ext cx="2931160" cy="497840"/>
            </a:xfrm>
            <a:custGeom>
              <a:avLst/>
              <a:gdLst/>
              <a:ahLst/>
              <a:cxnLst/>
              <a:rect l="l" t="t" r="r" b="b"/>
              <a:pathLst>
                <a:path w="2931160" h="497839">
                  <a:moveTo>
                    <a:pt x="69342" y="44196"/>
                  </a:moveTo>
                  <a:lnTo>
                    <a:pt x="0" y="44196"/>
                  </a:lnTo>
                  <a:lnTo>
                    <a:pt x="0" y="48768"/>
                  </a:lnTo>
                  <a:lnTo>
                    <a:pt x="69342" y="48768"/>
                  </a:lnTo>
                  <a:lnTo>
                    <a:pt x="69342" y="44196"/>
                  </a:lnTo>
                  <a:close/>
                </a:path>
                <a:path w="2931160" h="497839">
                  <a:moveTo>
                    <a:pt x="641591" y="44196"/>
                  </a:moveTo>
                  <a:lnTo>
                    <a:pt x="572262" y="44196"/>
                  </a:lnTo>
                  <a:lnTo>
                    <a:pt x="572262" y="83820"/>
                  </a:lnTo>
                  <a:lnTo>
                    <a:pt x="641591" y="83820"/>
                  </a:lnTo>
                  <a:lnTo>
                    <a:pt x="641591" y="44196"/>
                  </a:lnTo>
                  <a:close/>
                </a:path>
                <a:path w="2931160" h="497839">
                  <a:moveTo>
                    <a:pt x="1213866" y="0"/>
                  </a:moveTo>
                  <a:lnTo>
                    <a:pt x="1144524" y="0"/>
                  </a:lnTo>
                  <a:lnTo>
                    <a:pt x="1144524" y="44196"/>
                  </a:lnTo>
                  <a:lnTo>
                    <a:pt x="1213866" y="44196"/>
                  </a:lnTo>
                  <a:lnTo>
                    <a:pt x="1213866" y="0"/>
                  </a:lnTo>
                  <a:close/>
                </a:path>
                <a:path w="2931160" h="497839">
                  <a:moveTo>
                    <a:pt x="1786128" y="44196"/>
                  </a:moveTo>
                  <a:lnTo>
                    <a:pt x="1716786" y="44196"/>
                  </a:lnTo>
                  <a:lnTo>
                    <a:pt x="1716786" y="357378"/>
                  </a:lnTo>
                  <a:lnTo>
                    <a:pt x="1786128" y="357378"/>
                  </a:lnTo>
                  <a:lnTo>
                    <a:pt x="1786128" y="44196"/>
                  </a:lnTo>
                  <a:close/>
                </a:path>
                <a:path w="2931160" h="497839">
                  <a:moveTo>
                    <a:pt x="2358390" y="44196"/>
                  </a:moveTo>
                  <a:lnTo>
                    <a:pt x="2289810" y="44196"/>
                  </a:lnTo>
                  <a:lnTo>
                    <a:pt x="2289810" y="497586"/>
                  </a:lnTo>
                  <a:lnTo>
                    <a:pt x="2358390" y="497586"/>
                  </a:lnTo>
                  <a:lnTo>
                    <a:pt x="2358390" y="44196"/>
                  </a:lnTo>
                  <a:close/>
                </a:path>
                <a:path w="2931160" h="497839">
                  <a:moveTo>
                    <a:pt x="2930639" y="44196"/>
                  </a:moveTo>
                  <a:lnTo>
                    <a:pt x="2862072" y="44196"/>
                  </a:lnTo>
                  <a:lnTo>
                    <a:pt x="2862072" y="329184"/>
                  </a:lnTo>
                  <a:lnTo>
                    <a:pt x="2930639" y="329184"/>
                  </a:lnTo>
                  <a:lnTo>
                    <a:pt x="2930639" y="44196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4101846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4033266" y="3152393"/>
              <a:ext cx="68580" cy="535940"/>
            </a:xfrm>
            <a:custGeom>
              <a:avLst/>
              <a:gdLst/>
              <a:ahLst/>
              <a:cxnLst/>
              <a:rect l="l" t="t" r="r" b="b"/>
              <a:pathLst>
                <a:path w="68579" h="535939">
                  <a:moveTo>
                    <a:pt x="68579" y="0"/>
                  </a:moveTo>
                  <a:lnTo>
                    <a:pt x="0" y="0"/>
                  </a:lnTo>
                  <a:lnTo>
                    <a:pt x="0" y="535686"/>
                  </a:lnTo>
                  <a:lnTo>
                    <a:pt x="68579" y="535686"/>
                  </a:lnTo>
                  <a:lnTo>
                    <a:pt x="68579" y="0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3" name="object 53"/>
            <p:cNvSpPr/>
            <p:nvPr/>
          </p:nvSpPr>
          <p:spPr>
            <a:xfrm>
              <a:off x="4674108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4" name="object 54"/>
            <p:cNvSpPr/>
            <p:nvPr/>
          </p:nvSpPr>
          <p:spPr>
            <a:xfrm>
              <a:off x="4674108" y="2985515"/>
              <a:ext cx="19050" cy="5080"/>
            </a:xfrm>
            <a:custGeom>
              <a:avLst/>
              <a:gdLst/>
              <a:ahLst/>
              <a:cxnLst/>
              <a:rect l="l" t="t" r="r" b="b"/>
              <a:pathLst>
                <a:path w="19050" h="5080">
                  <a:moveTo>
                    <a:pt x="0" y="4952"/>
                  </a:moveTo>
                  <a:lnTo>
                    <a:pt x="19050" y="4952"/>
                  </a:lnTo>
                </a:path>
                <a:path w="19050" h="508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5" name="object 55"/>
            <p:cNvSpPr/>
            <p:nvPr/>
          </p:nvSpPr>
          <p:spPr>
            <a:xfrm>
              <a:off x="4605528" y="2977133"/>
              <a:ext cx="68580" cy="711200"/>
            </a:xfrm>
            <a:custGeom>
              <a:avLst/>
              <a:gdLst/>
              <a:ahLst/>
              <a:cxnLst/>
              <a:rect l="l" t="t" r="r" b="b"/>
              <a:pathLst>
                <a:path w="68579" h="711200">
                  <a:moveTo>
                    <a:pt x="68579" y="0"/>
                  </a:moveTo>
                  <a:lnTo>
                    <a:pt x="0" y="0"/>
                  </a:lnTo>
                  <a:lnTo>
                    <a:pt x="0" y="710945"/>
                  </a:lnTo>
                  <a:lnTo>
                    <a:pt x="68579" y="710945"/>
                  </a:lnTo>
                  <a:lnTo>
                    <a:pt x="68579" y="0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6"/>
            <p:cNvSpPr/>
            <p:nvPr/>
          </p:nvSpPr>
          <p:spPr>
            <a:xfrm>
              <a:off x="5247131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4">
                  <a:moveTo>
                    <a:pt x="0" y="0"/>
                  </a:moveTo>
                  <a:lnTo>
                    <a:pt x="18288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5177790" y="3278885"/>
              <a:ext cx="1786255" cy="715645"/>
            </a:xfrm>
            <a:custGeom>
              <a:avLst/>
              <a:gdLst/>
              <a:ahLst/>
              <a:cxnLst/>
              <a:rect l="l" t="t" r="r" b="b"/>
              <a:pathLst>
                <a:path w="1786254" h="715645">
                  <a:moveTo>
                    <a:pt x="69329" y="0"/>
                  </a:moveTo>
                  <a:lnTo>
                    <a:pt x="0" y="0"/>
                  </a:lnTo>
                  <a:lnTo>
                    <a:pt x="0" y="409194"/>
                  </a:lnTo>
                  <a:lnTo>
                    <a:pt x="69329" y="409194"/>
                  </a:lnTo>
                  <a:lnTo>
                    <a:pt x="69329" y="0"/>
                  </a:lnTo>
                  <a:close/>
                </a:path>
                <a:path w="1786254" h="715645">
                  <a:moveTo>
                    <a:pt x="641591" y="409194"/>
                  </a:moveTo>
                  <a:lnTo>
                    <a:pt x="572262" y="409194"/>
                  </a:lnTo>
                  <a:lnTo>
                    <a:pt x="572262" y="575310"/>
                  </a:lnTo>
                  <a:lnTo>
                    <a:pt x="641591" y="575310"/>
                  </a:lnTo>
                  <a:lnTo>
                    <a:pt x="641591" y="409194"/>
                  </a:lnTo>
                  <a:close/>
                </a:path>
                <a:path w="1786254" h="715645">
                  <a:moveTo>
                    <a:pt x="1213866" y="409194"/>
                  </a:moveTo>
                  <a:lnTo>
                    <a:pt x="1144524" y="409194"/>
                  </a:lnTo>
                  <a:lnTo>
                    <a:pt x="1144524" y="715518"/>
                  </a:lnTo>
                  <a:lnTo>
                    <a:pt x="1213866" y="715518"/>
                  </a:lnTo>
                  <a:lnTo>
                    <a:pt x="1213866" y="409194"/>
                  </a:lnTo>
                  <a:close/>
                </a:path>
                <a:path w="1786254" h="715645">
                  <a:moveTo>
                    <a:pt x="1786128" y="409194"/>
                  </a:moveTo>
                  <a:lnTo>
                    <a:pt x="1716786" y="409194"/>
                  </a:lnTo>
                  <a:lnTo>
                    <a:pt x="1716786" y="672846"/>
                  </a:lnTo>
                  <a:lnTo>
                    <a:pt x="1786128" y="672846"/>
                  </a:lnTo>
                  <a:lnTo>
                    <a:pt x="1786128" y="409194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5510784" y="3337178"/>
              <a:ext cx="2219960" cy="0"/>
            </a:xfrm>
            <a:custGeom>
              <a:avLst/>
              <a:gdLst/>
              <a:ahLst/>
              <a:cxnLst/>
              <a:rect l="l" t="t" r="r" b="b"/>
              <a:pathLst>
                <a:path w="2219959">
                  <a:moveTo>
                    <a:pt x="0" y="0"/>
                  </a:moveTo>
                  <a:lnTo>
                    <a:pt x="1956054" y="0"/>
                  </a:lnTo>
                </a:path>
                <a:path w="2219959">
                  <a:moveTo>
                    <a:pt x="2025396" y="0"/>
                  </a:moveTo>
                  <a:lnTo>
                    <a:pt x="2219706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7466838" y="3320795"/>
              <a:ext cx="641985" cy="367665"/>
            </a:xfrm>
            <a:custGeom>
              <a:avLst/>
              <a:gdLst/>
              <a:ahLst/>
              <a:cxnLst/>
              <a:rect l="l" t="t" r="r" b="b"/>
              <a:pathLst>
                <a:path w="641984" h="367664">
                  <a:moveTo>
                    <a:pt x="69342" y="0"/>
                  </a:moveTo>
                  <a:lnTo>
                    <a:pt x="0" y="0"/>
                  </a:lnTo>
                  <a:lnTo>
                    <a:pt x="0" y="367296"/>
                  </a:lnTo>
                  <a:lnTo>
                    <a:pt x="69342" y="367296"/>
                  </a:lnTo>
                  <a:lnTo>
                    <a:pt x="69342" y="0"/>
                  </a:lnTo>
                  <a:close/>
                </a:path>
                <a:path w="641984" h="367664">
                  <a:moveTo>
                    <a:pt x="641604" y="119634"/>
                  </a:moveTo>
                  <a:lnTo>
                    <a:pt x="572262" y="119634"/>
                  </a:lnTo>
                  <a:lnTo>
                    <a:pt x="572262" y="367284"/>
                  </a:lnTo>
                  <a:lnTo>
                    <a:pt x="641604" y="367284"/>
                  </a:lnTo>
                  <a:lnTo>
                    <a:pt x="641604" y="119634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8680703" y="3336035"/>
              <a:ext cx="106680" cy="5080"/>
            </a:xfrm>
            <a:custGeom>
              <a:avLst/>
              <a:gdLst/>
              <a:ahLst/>
              <a:cxnLst/>
              <a:rect l="l" t="t" r="r" b="b"/>
              <a:pathLst>
                <a:path w="106679" h="5079">
                  <a:moveTo>
                    <a:pt x="0" y="4952"/>
                  </a:moveTo>
                  <a:lnTo>
                    <a:pt x="106679" y="4952"/>
                  </a:lnTo>
                </a:path>
                <a:path w="106679" h="5079">
                  <a:moveTo>
                    <a:pt x="0" y="0"/>
                  </a:moveTo>
                  <a:lnTo>
                    <a:pt x="106679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8611362" y="3173729"/>
              <a:ext cx="69850" cy="514350"/>
            </a:xfrm>
            <a:custGeom>
              <a:avLst/>
              <a:gdLst/>
              <a:ahLst/>
              <a:cxnLst/>
              <a:rect l="l" t="t" r="r" b="b"/>
              <a:pathLst>
                <a:path w="69850" h="514350">
                  <a:moveTo>
                    <a:pt x="69342" y="0"/>
                  </a:moveTo>
                  <a:lnTo>
                    <a:pt x="0" y="0"/>
                  </a:lnTo>
                  <a:lnTo>
                    <a:pt x="0" y="514350"/>
                  </a:lnTo>
                  <a:lnTo>
                    <a:pt x="69342" y="514350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2" name="object 62"/>
            <p:cNvSpPr/>
            <p:nvPr/>
          </p:nvSpPr>
          <p:spPr>
            <a:xfrm>
              <a:off x="9252965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5">
                  <a:moveTo>
                    <a:pt x="0" y="0"/>
                  </a:moveTo>
                  <a:lnTo>
                    <a:pt x="1828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9183624" y="3222497"/>
              <a:ext cx="69850" cy="466090"/>
            </a:xfrm>
            <a:custGeom>
              <a:avLst/>
              <a:gdLst/>
              <a:ahLst/>
              <a:cxnLst/>
              <a:rect l="l" t="t" r="r" b="b"/>
              <a:pathLst>
                <a:path w="69850" h="466089">
                  <a:moveTo>
                    <a:pt x="69342" y="0"/>
                  </a:moveTo>
                  <a:lnTo>
                    <a:pt x="0" y="0"/>
                  </a:lnTo>
                  <a:lnTo>
                    <a:pt x="0" y="465581"/>
                  </a:lnTo>
                  <a:lnTo>
                    <a:pt x="69342" y="465581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9825227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5">
                  <a:moveTo>
                    <a:pt x="0" y="0"/>
                  </a:moveTo>
                  <a:lnTo>
                    <a:pt x="18288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5" name="object 65"/>
            <p:cNvSpPr/>
            <p:nvPr/>
          </p:nvSpPr>
          <p:spPr>
            <a:xfrm>
              <a:off x="9755886" y="3285743"/>
              <a:ext cx="69850" cy="402590"/>
            </a:xfrm>
            <a:custGeom>
              <a:avLst/>
              <a:gdLst/>
              <a:ahLst/>
              <a:cxnLst/>
              <a:rect l="l" t="t" r="r" b="b"/>
              <a:pathLst>
                <a:path w="69850" h="402589">
                  <a:moveTo>
                    <a:pt x="69342" y="0"/>
                  </a:moveTo>
                  <a:lnTo>
                    <a:pt x="0" y="0"/>
                  </a:lnTo>
                  <a:lnTo>
                    <a:pt x="0" y="402336"/>
                  </a:lnTo>
                  <a:lnTo>
                    <a:pt x="69342" y="402336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10397489" y="3337178"/>
              <a:ext cx="106680" cy="0"/>
            </a:xfrm>
            <a:custGeom>
              <a:avLst/>
              <a:gdLst/>
              <a:ahLst/>
              <a:cxnLst/>
              <a:rect l="l" t="t" r="r" b="b"/>
              <a:pathLst>
                <a:path w="106679">
                  <a:moveTo>
                    <a:pt x="0" y="0"/>
                  </a:moveTo>
                  <a:lnTo>
                    <a:pt x="106679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10328148" y="3278885"/>
              <a:ext cx="641985" cy="409575"/>
            </a:xfrm>
            <a:custGeom>
              <a:avLst/>
              <a:gdLst/>
              <a:ahLst/>
              <a:cxnLst/>
              <a:rect l="l" t="t" r="r" b="b"/>
              <a:pathLst>
                <a:path w="641984" h="409575">
                  <a:moveTo>
                    <a:pt x="69342" y="0"/>
                  </a:moveTo>
                  <a:lnTo>
                    <a:pt x="0" y="0"/>
                  </a:lnTo>
                  <a:lnTo>
                    <a:pt x="0" y="409194"/>
                  </a:lnTo>
                  <a:lnTo>
                    <a:pt x="69342" y="409194"/>
                  </a:lnTo>
                  <a:lnTo>
                    <a:pt x="69342" y="0"/>
                  </a:lnTo>
                  <a:close/>
                </a:path>
                <a:path w="641984" h="409575">
                  <a:moveTo>
                    <a:pt x="641604" y="131826"/>
                  </a:moveTo>
                  <a:lnTo>
                    <a:pt x="572262" y="131826"/>
                  </a:lnTo>
                  <a:lnTo>
                    <a:pt x="572262" y="409194"/>
                  </a:lnTo>
                  <a:lnTo>
                    <a:pt x="641604" y="409194"/>
                  </a:lnTo>
                  <a:lnTo>
                    <a:pt x="641604" y="131826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11542014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11472672" y="3236975"/>
              <a:ext cx="69850" cy="451484"/>
            </a:xfrm>
            <a:custGeom>
              <a:avLst/>
              <a:gdLst/>
              <a:ahLst/>
              <a:cxnLst/>
              <a:rect l="l" t="t" r="r" b="b"/>
              <a:pathLst>
                <a:path w="69850" h="451485">
                  <a:moveTo>
                    <a:pt x="69342" y="0"/>
                  </a:moveTo>
                  <a:lnTo>
                    <a:pt x="0" y="0"/>
                  </a:lnTo>
                  <a:lnTo>
                    <a:pt x="0" y="451104"/>
                  </a:lnTo>
                  <a:lnTo>
                    <a:pt x="69342" y="451104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8AC145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687324" y="3430523"/>
              <a:ext cx="2931160" cy="477520"/>
            </a:xfrm>
            <a:custGeom>
              <a:avLst/>
              <a:gdLst/>
              <a:ahLst/>
              <a:cxnLst/>
              <a:rect l="l" t="t" r="r" b="b"/>
              <a:pathLst>
                <a:path w="2931160" h="477520">
                  <a:moveTo>
                    <a:pt x="68567" y="257556"/>
                  </a:moveTo>
                  <a:lnTo>
                    <a:pt x="0" y="257556"/>
                  </a:lnTo>
                  <a:lnTo>
                    <a:pt x="0" y="393192"/>
                  </a:lnTo>
                  <a:lnTo>
                    <a:pt x="68567" y="393192"/>
                  </a:lnTo>
                  <a:lnTo>
                    <a:pt x="68567" y="257556"/>
                  </a:lnTo>
                  <a:close/>
                </a:path>
                <a:path w="2931160" h="477520">
                  <a:moveTo>
                    <a:pt x="641604" y="182880"/>
                  </a:moveTo>
                  <a:lnTo>
                    <a:pt x="572262" y="182880"/>
                  </a:lnTo>
                  <a:lnTo>
                    <a:pt x="572262" y="257556"/>
                  </a:lnTo>
                  <a:lnTo>
                    <a:pt x="641604" y="257556"/>
                  </a:lnTo>
                  <a:lnTo>
                    <a:pt x="641604" y="182880"/>
                  </a:lnTo>
                  <a:close/>
                </a:path>
                <a:path w="2931160" h="477520">
                  <a:moveTo>
                    <a:pt x="1213866" y="196596"/>
                  </a:moveTo>
                  <a:lnTo>
                    <a:pt x="1144524" y="196596"/>
                  </a:lnTo>
                  <a:lnTo>
                    <a:pt x="1144524" y="257556"/>
                  </a:lnTo>
                  <a:lnTo>
                    <a:pt x="1213866" y="257556"/>
                  </a:lnTo>
                  <a:lnTo>
                    <a:pt x="1213866" y="196596"/>
                  </a:lnTo>
                  <a:close/>
                </a:path>
                <a:path w="2931160" h="477520">
                  <a:moveTo>
                    <a:pt x="1786128" y="0"/>
                  </a:moveTo>
                  <a:lnTo>
                    <a:pt x="1716786" y="0"/>
                  </a:lnTo>
                  <a:lnTo>
                    <a:pt x="1716786" y="257556"/>
                  </a:lnTo>
                  <a:lnTo>
                    <a:pt x="1786128" y="257556"/>
                  </a:lnTo>
                  <a:lnTo>
                    <a:pt x="1786128" y="0"/>
                  </a:lnTo>
                  <a:close/>
                </a:path>
                <a:path w="2931160" h="477520">
                  <a:moveTo>
                    <a:pt x="2358390" y="35052"/>
                  </a:moveTo>
                  <a:lnTo>
                    <a:pt x="2289048" y="35052"/>
                  </a:lnTo>
                  <a:lnTo>
                    <a:pt x="2289048" y="257556"/>
                  </a:lnTo>
                  <a:lnTo>
                    <a:pt x="2358390" y="257556"/>
                  </a:lnTo>
                  <a:lnTo>
                    <a:pt x="2358390" y="35052"/>
                  </a:lnTo>
                  <a:close/>
                </a:path>
                <a:path w="2931160" h="477520">
                  <a:moveTo>
                    <a:pt x="2930652" y="257556"/>
                  </a:moveTo>
                  <a:lnTo>
                    <a:pt x="2861310" y="257556"/>
                  </a:lnTo>
                  <a:lnTo>
                    <a:pt x="2861310" y="477012"/>
                  </a:lnTo>
                  <a:lnTo>
                    <a:pt x="2930652" y="477012"/>
                  </a:lnTo>
                  <a:lnTo>
                    <a:pt x="2930652" y="257556"/>
                  </a:lnTo>
                  <a:close/>
                </a:path>
              </a:pathLst>
            </a:custGeom>
            <a:solidFill>
              <a:srgbClr val="36AEC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4190237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4">
                  <a:moveTo>
                    <a:pt x="0" y="0"/>
                  </a:moveTo>
                  <a:lnTo>
                    <a:pt x="1828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4120896" y="3143249"/>
              <a:ext cx="69850" cy="544830"/>
            </a:xfrm>
            <a:custGeom>
              <a:avLst/>
              <a:gdLst/>
              <a:ahLst/>
              <a:cxnLst/>
              <a:rect l="l" t="t" r="r" b="b"/>
              <a:pathLst>
                <a:path w="69850" h="544829">
                  <a:moveTo>
                    <a:pt x="69341" y="0"/>
                  </a:moveTo>
                  <a:lnTo>
                    <a:pt x="0" y="0"/>
                  </a:lnTo>
                  <a:lnTo>
                    <a:pt x="0" y="544830"/>
                  </a:lnTo>
                  <a:lnTo>
                    <a:pt x="69341" y="544830"/>
                  </a:lnTo>
                  <a:lnTo>
                    <a:pt x="69341" y="0"/>
                  </a:lnTo>
                  <a:close/>
                </a:path>
              </a:pathLst>
            </a:custGeom>
            <a:solidFill>
              <a:srgbClr val="36AEC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4762499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4">
                  <a:moveTo>
                    <a:pt x="0" y="0"/>
                  </a:moveTo>
                  <a:lnTo>
                    <a:pt x="1828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4762499" y="2985515"/>
              <a:ext cx="106680" cy="5080"/>
            </a:xfrm>
            <a:custGeom>
              <a:avLst/>
              <a:gdLst/>
              <a:ahLst/>
              <a:cxnLst/>
              <a:rect l="l" t="t" r="r" b="b"/>
              <a:pathLst>
                <a:path w="106679" h="5080">
                  <a:moveTo>
                    <a:pt x="0" y="4952"/>
                  </a:moveTo>
                  <a:lnTo>
                    <a:pt x="106679" y="4952"/>
                  </a:lnTo>
                </a:path>
                <a:path w="106679" h="5080">
                  <a:moveTo>
                    <a:pt x="0" y="0"/>
                  </a:moveTo>
                  <a:lnTo>
                    <a:pt x="106679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4693158" y="2954273"/>
              <a:ext cx="69850" cy="734060"/>
            </a:xfrm>
            <a:custGeom>
              <a:avLst/>
              <a:gdLst/>
              <a:ahLst/>
              <a:cxnLst/>
              <a:rect l="l" t="t" r="r" b="b"/>
              <a:pathLst>
                <a:path w="69850" h="734060">
                  <a:moveTo>
                    <a:pt x="69341" y="0"/>
                  </a:moveTo>
                  <a:lnTo>
                    <a:pt x="0" y="0"/>
                  </a:lnTo>
                  <a:lnTo>
                    <a:pt x="0" y="733806"/>
                  </a:lnTo>
                  <a:lnTo>
                    <a:pt x="69341" y="733806"/>
                  </a:lnTo>
                  <a:lnTo>
                    <a:pt x="69341" y="0"/>
                  </a:lnTo>
                  <a:close/>
                </a:path>
              </a:pathLst>
            </a:custGeom>
            <a:solidFill>
              <a:srgbClr val="36AEC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5334761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4">
                  <a:moveTo>
                    <a:pt x="0" y="0"/>
                  </a:moveTo>
                  <a:lnTo>
                    <a:pt x="1828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4937760" y="2985515"/>
              <a:ext cx="4333875" cy="5080"/>
            </a:xfrm>
            <a:custGeom>
              <a:avLst/>
              <a:gdLst/>
              <a:ahLst/>
              <a:cxnLst/>
              <a:rect l="l" t="t" r="r" b="b"/>
              <a:pathLst>
                <a:path w="4333875" h="5080">
                  <a:moveTo>
                    <a:pt x="0" y="4952"/>
                  </a:moveTo>
                  <a:lnTo>
                    <a:pt x="327660" y="4952"/>
                  </a:lnTo>
                </a:path>
                <a:path w="4333875" h="5080">
                  <a:moveTo>
                    <a:pt x="0" y="0"/>
                  </a:moveTo>
                  <a:lnTo>
                    <a:pt x="327660" y="0"/>
                  </a:lnTo>
                </a:path>
                <a:path w="4333875" h="5080">
                  <a:moveTo>
                    <a:pt x="397002" y="4952"/>
                  </a:moveTo>
                  <a:lnTo>
                    <a:pt x="4333494" y="4952"/>
                  </a:lnTo>
                </a:path>
                <a:path w="4333875" h="5080">
                  <a:moveTo>
                    <a:pt x="397002" y="0"/>
                  </a:moveTo>
                  <a:lnTo>
                    <a:pt x="4333494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435483" y="2636138"/>
              <a:ext cx="11446510" cy="0"/>
            </a:xfrm>
            <a:custGeom>
              <a:avLst/>
              <a:gdLst/>
              <a:ahLst/>
              <a:cxnLst/>
              <a:rect l="l" t="t" r="r" b="b"/>
              <a:pathLst>
                <a:path w="11446510">
                  <a:moveTo>
                    <a:pt x="0" y="0"/>
                  </a:moveTo>
                  <a:lnTo>
                    <a:pt x="11446002" y="0"/>
                  </a:lnTo>
                </a:path>
              </a:pathLst>
            </a:custGeom>
            <a:ln w="9906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5265420" y="2659379"/>
              <a:ext cx="2358390" cy="1031240"/>
            </a:xfrm>
            <a:custGeom>
              <a:avLst/>
              <a:gdLst/>
              <a:ahLst/>
              <a:cxnLst/>
              <a:rect l="l" t="t" r="r" b="b"/>
              <a:pathLst>
                <a:path w="2358390" h="1031239">
                  <a:moveTo>
                    <a:pt x="69342" y="0"/>
                  </a:moveTo>
                  <a:lnTo>
                    <a:pt x="0" y="0"/>
                  </a:lnTo>
                  <a:lnTo>
                    <a:pt x="0" y="1028700"/>
                  </a:lnTo>
                  <a:lnTo>
                    <a:pt x="69342" y="1028700"/>
                  </a:lnTo>
                  <a:lnTo>
                    <a:pt x="69342" y="0"/>
                  </a:lnTo>
                  <a:close/>
                </a:path>
                <a:path w="2358390" h="1031239">
                  <a:moveTo>
                    <a:pt x="641604" y="897636"/>
                  </a:moveTo>
                  <a:lnTo>
                    <a:pt x="572262" y="897636"/>
                  </a:lnTo>
                  <a:lnTo>
                    <a:pt x="572262" y="1028700"/>
                  </a:lnTo>
                  <a:lnTo>
                    <a:pt x="641604" y="1028700"/>
                  </a:lnTo>
                  <a:lnTo>
                    <a:pt x="641604" y="897636"/>
                  </a:lnTo>
                  <a:close/>
                </a:path>
                <a:path w="2358390" h="1031239">
                  <a:moveTo>
                    <a:pt x="1213866" y="806196"/>
                  </a:moveTo>
                  <a:lnTo>
                    <a:pt x="1144524" y="806196"/>
                  </a:lnTo>
                  <a:lnTo>
                    <a:pt x="1144524" y="1028700"/>
                  </a:lnTo>
                  <a:lnTo>
                    <a:pt x="1213866" y="1028700"/>
                  </a:lnTo>
                  <a:lnTo>
                    <a:pt x="1213866" y="806196"/>
                  </a:lnTo>
                  <a:close/>
                </a:path>
                <a:path w="2358390" h="1031239">
                  <a:moveTo>
                    <a:pt x="1786128" y="1028700"/>
                  </a:moveTo>
                  <a:lnTo>
                    <a:pt x="1716786" y="1028700"/>
                  </a:lnTo>
                  <a:lnTo>
                    <a:pt x="1716786" y="1030986"/>
                  </a:lnTo>
                  <a:lnTo>
                    <a:pt x="1786128" y="1030986"/>
                  </a:lnTo>
                  <a:lnTo>
                    <a:pt x="1786128" y="1028700"/>
                  </a:lnTo>
                  <a:close/>
                </a:path>
                <a:path w="2358390" h="1031239">
                  <a:moveTo>
                    <a:pt x="2358390" y="995934"/>
                  </a:moveTo>
                  <a:lnTo>
                    <a:pt x="2289048" y="995934"/>
                  </a:lnTo>
                  <a:lnTo>
                    <a:pt x="2289048" y="1028700"/>
                  </a:lnTo>
                  <a:lnTo>
                    <a:pt x="2358390" y="1028700"/>
                  </a:lnTo>
                  <a:lnTo>
                    <a:pt x="2358390" y="995934"/>
                  </a:lnTo>
                  <a:close/>
                </a:path>
              </a:pathLst>
            </a:custGeom>
            <a:solidFill>
              <a:srgbClr val="36AEC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8196072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8126730" y="3073145"/>
              <a:ext cx="641985" cy="615315"/>
            </a:xfrm>
            <a:custGeom>
              <a:avLst/>
              <a:gdLst/>
              <a:ahLst/>
              <a:cxnLst/>
              <a:rect l="l" t="t" r="r" b="b"/>
              <a:pathLst>
                <a:path w="641984" h="615314">
                  <a:moveTo>
                    <a:pt x="69342" y="0"/>
                  </a:moveTo>
                  <a:lnTo>
                    <a:pt x="0" y="0"/>
                  </a:lnTo>
                  <a:lnTo>
                    <a:pt x="0" y="614946"/>
                  </a:lnTo>
                  <a:lnTo>
                    <a:pt x="69342" y="614946"/>
                  </a:lnTo>
                  <a:lnTo>
                    <a:pt x="69342" y="0"/>
                  </a:lnTo>
                  <a:close/>
                </a:path>
                <a:path w="641984" h="615314">
                  <a:moveTo>
                    <a:pt x="641604" y="266700"/>
                  </a:moveTo>
                  <a:lnTo>
                    <a:pt x="572262" y="266700"/>
                  </a:lnTo>
                  <a:lnTo>
                    <a:pt x="572262" y="614946"/>
                  </a:lnTo>
                  <a:lnTo>
                    <a:pt x="641604" y="614946"/>
                  </a:lnTo>
                  <a:lnTo>
                    <a:pt x="641604" y="266700"/>
                  </a:lnTo>
                  <a:close/>
                </a:path>
              </a:pathLst>
            </a:custGeom>
            <a:solidFill>
              <a:srgbClr val="36AEC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9340596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9340596" y="2985515"/>
              <a:ext cx="106680" cy="5080"/>
            </a:xfrm>
            <a:custGeom>
              <a:avLst/>
              <a:gdLst/>
              <a:ahLst/>
              <a:cxnLst/>
              <a:rect l="l" t="t" r="r" b="b"/>
              <a:pathLst>
                <a:path w="106679" h="5080">
                  <a:moveTo>
                    <a:pt x="0" y="4952"/>
                  </a:moveTo>
                  <a:lnTo>
                    <a:pt x="106679" y="4952"/>
                  </a:lnTo>
                </a:path>
                <a:path w="106679" h="5080">
                  <a:moveTo>
                    <a:pt x="0" y="0"/>
                  </a:moveTo>
                  <a:lnTo>
                    <a:pt x="106679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9271253" y="2855975"/>
              <a:ext cx="69850" cy="832485"/>
            </a:xfrm>
            <a:custGeom>
              <a:avLst/>
              <a:gdLst/>
              <a:ahLst/>
              <a:cxnLst/>
              <a:rect l="l" t="t" r="r" b="b"/>
              <a:pathLst>
                <a:path w="69850" h="832485">
                  <a:moveTo>
                    <a:pt x="69342" y="0"/>
                  </a:moveTo>
                  <a:lnTo>
                    <a:pt x="0" y="0"/>
                  </a:lnTo>
                  <a:lnTo>
                    <a:pt x="0" y="832103"/>
                  </a:lnTo>
                  <a:lnTo>
                    <a:pt x="69342" y="832103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36AEC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9912858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49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9843516" y="3094481"/>
              <a:ext cx="641985" cy="593725"/>
            </a:xfrm>
            <a:custGeom>
              <a:avLst/>
              <a:gdLst/>
              <a:ahLst/>
              <a:cxnLst/>
              <a:rect l="l" t="t" r="r" b="b"/>
              <a:pathLst>
                <a:path w="641984" h="593725">
                  <a:moveTo>
                    <a:pt x="69342" y="0"/>
                  </a:moveTo>
                  <a:lnTo>
                    <a:pt x="0" y="0"/>
                  </a:lnTo>
                  <a:lnTo>
                    <a:pt x="0" y="593610"/>
                  </a:lnTo>
                  <a:lnTo>
                    <a:pt x="69342" y="593610"/>
                  </a:lnTo>
                  <a:lnTo>
                    <a:pt x="69342" y="0"/>
                  </a:lnTo>
                  <a:close/>
                </a:path>
                <a:path w="641984" h="593725">
                  <a:moveTo>
                    <a:pt x="641604" y="476262"/>
                  </a:moveTo>
                  <a:lnTo>
                    <a:pt x="572262" y="476262"/>
                  </a:lnTo>
                  <a:lnTo>
                    <a:pt x="572262" y="593610"/>
                  </a:lnTo>
                  <a:lnTo>
                    <a:pt x="641604" y="593610"/>
                  </a:lnTo>
                  <a:lnTo>
                    <a:pt x="641604" y="476262"/>
                  </a:lnTo>
                  <a:close/>
                </a:path>
              </a:pathLst>
            </a:custGeom>
            <a:solidFill>
              <a:srgbClr val="36AEC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10661141" y="3337178"/>
              <a:ext cx="415290" cy="0"/>
            </a:xfrm>
            <a:custGeom>
              <a:avLst/>
              <a:gdLst/>
              <a:ahLst/>
              <a:cxnLst/>
              <a:rect l="l" t="t" r="r" b="b"/>
              <a:pathLst>
                <a:path w="415290">
                  <a:moveTo>
                    <a:pt x="0" y="0"/>
                  </a:moveTo>
                  <a:lnTo>
                    <a:pt x="327659" y="0"/>
                  </a:lnTo>
                </a:path>
                <a:path w="415290">
                  <a:moveTo>
                    <a:pt x="396239" y="0"/>
                  </a:moveTo>
                  <a:lnTo>
                    <a:pt x="415289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8"/>
            <p:cNvSpPr/>
            <p:nvPr/>
          </p:nvSpPr>
          <p:spPr>
            <a:xfrm>
              <a:off x="10988801" y="3255263"/>
              <a:ext cx="68580" cy="433070"/>
            </a:xfrm>
            <a:custGeom>
              <a:avLst/>
              <a:gdLst/>
              <a:ahLst/>
              <a:cxnLst/>
              <a:rect l="l" t="t" r="r" b="b"/>
              <a:pathLst>
                <a:path w="68579" h="433070">
                  <a:moveTo>
                    <a:pt x="68579" y="0"/>
                  </a:moveTo>
                  <a:lnTo>
                    <a:pt x="0" y="0"/>
                  </a:lnTo>
                  <a:lnTo>
                    <a:pt x="0" y="432815"/>
                  </a:lnTo>
                  <a:lnTo>
                    <a:pt x="68579" y="432815"/>
                  </a:lnTo>
                  <a:lnTo>
                    <a:pt x="68579" y="0"/>
                  </a:lnTo>
                  <a:close/>
                </a:path>
              </a:pathLst>
            </a:custGeom>
            <a:solidFill>
              <a:srgbClr val="36AEC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89"/>
            <p:cNvSpPr/>
            <p:nvPr/>
          </p:nvSpPr>
          <p:spPr>
            <a:xfrm>
              <a:off x="11629643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11561064" y="3149345"/>
              <a:ext cx="68580" cy="539115"/>
            </a:xfrm>
            <a:custGeom>
              <a:avLst/>
              <a:gdLst/>
              <a:ahLst/>
              <a:cxnLst/>
              <a:rect l="l" t="t" r="r" b="b"/>
              <a:pathLst>
                <a:path w="68579" h="539114">
                  <a:moveTo>
                    <a:pt x="68579" y="0"/>
                  </a:moveTo>
                  <a:lnTo>
                    <a:pt x="0" y="0"/>
                  </a:lnTo>
                  <a:lnTo>
                    <a:pt x="0" y="538734"/>
                  </a:lnTo>
                  <a:lnTo>
                    <a:pt x="68579" y="538734"/>
                  </a:lnTo>
                  <a:lnTo>
                    <a:pt x="68579" y="0"/>
                  </a:lnTo>
                  <a:close/>
                </a:path>
              </a:pathLst>
            </a:custGeom>
            <a:solidFill>
              <a:srgbClr val="36AECE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91"/>
            <p:cNvSpPr/>
            <p:nvPr/>
          </p:nvSpPr>
          <p:spPr>
            <a:xfrm>
              <a:off x="774954" y="3673601"/>
              <a:ext cx="2931160" cy="273685"/>
            </a:xfrm>
            <a:custGeom>
              <a:avLst/>
              <a:gdLst/>
              <a:ahLst/>
              <a:cxnLst/>
              <a:rect l="l" t="t" r="r" b="b"/>
              <a:pathLst>
                <a:path w="2931160" h="273685">
                  <a:moveTo>
                    <a:pt x="69342" y="14478"/>
                  </a:moveTo>
                  <a:lnTo>
                    <a:pt x="0" y="14478"/>
                  </a:lnTo>
                  <a:lnTo>
                    <a:pt x="0" y="21336"/>
                  </a:lnTo>
                  <a:lnTo>
                    <a:pt x="69342" y="21336"/>
                  </a:lnTo>
                  <a:lnTo>
                    <a:pt x="69342" y="14478"/>
                  </a:lnTo>
                  <a:close/>
                </a:path>
                <a:path w="2931160" h="273685">
                  <a:moveTo>
                    <a:pt x="641591" y="0"/>
                  </a:moveTo>
                  <a:lnTo>
                    <a:pt x="572262" y="0"/>
                  </a:lnTo>
                  <a:lnTo>
                    <a:pt x="572262" y="14478"/>
                  </a:lnTo>
                  <a:lnTo>
                    <a:pt x="641591" y="14478"/>
                  </a:lnTo>
                  <a:lnTo>
                    <a:pt x="641591" y="0"/>
                  </a:lnTo>
                  <a:close/>
                </a:path>
                <a:path w="2931160" h="273685">
                  <a:moveTo>
                    <a:pt x="1213866" y="14478"/>
                  </a:moveTo>
                  <a:lnTo>
                    <a:pt x="1144524" y="14478"/>
                  </a:lnTo>
                  <a:lnTo>
                    <a:pt x="1144524" y="21336"/>
                  </a:lnTo>
                  <a:lnTo>
                    <a:pt x="1213866" y="21336"/>
                  </a:lnTo>
                  <a:lnTo>
                    <a:pt x="1213866" y="14478"/>
                  </a:lnTo>
                  <a:close/>
                </a:path>
                <a:path w="2931160" h="273685">
                  <a:moveTo>
                    <a:pt x="1786128" y="14478"/>
                  </a:moveTo>
                  <a:lnTo>
                    <a:pt x="1716786" y="14478"/>
                  </a:lnTo>
                  <a:lnTo>
                    <a:pt x="1716786" y="133350"/>
                  </a:lnTo>
                  <a:lnTo>
                    <a:pt x="1786128" y="133350"/>
                  </a:lnTo>
                  <a:lnTo>
                    <a:pt x="1786128" y="14478"/>
                  </a:lnTo>
                  <a:close/>
                </a:path>
                <a:path w="2931160" h="273685">
                  <a:moveTo>
                    <a:pt x="2358390" y="14478"/>
                  </a:moveTo>
                  <a:lnTo>
                    <a:pt x="2289048" y="14478"/>
                  </a:lnTo>
                  <a:lnTo>
                    <a:pt x="2289048" y="273558"/>
                  </a:lnTo>
                  <a:lnTo>
                    <a:pt x="2358390" y="273558"/>
                  </a:lnTo>
                  <a:lnTo>
                    <a:pt x="2358390" y="14478"/>
                  </a:lnTo>
                  <a:close/>
                </a:path>
                <a:path w="2931160" h="273685">
                  <a:moveTo>
                    <a:pt x="2930652" y="14478"/>
                  </a:moveTo>
                  <a:lnTo>
                    <a:pt x="2861310" y="14478"/>
                  </a:lnTo>
                  <a:lnTo>
                    <a:pt x="2861310" y="56388"/>
                  </a:lnTo>
                  <a:lnTo>
                    <a:pt x="2930652" y="56388"/>
                  </a:lnTo>
                  <a:lnTo>
                    <a:pt x="2930652" y="14478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92"/>
            <p:cNvSpPr/>
            <p:nvPr/>
          </p:nvSpPr>
          <p:spPr>
            <a:xfrm>
              <a:off x="4277867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435483" y="2985515"/>
              <a:ext cx="3861435" cy="5080"/>
            </a:xfrm>
            <a:custGeom>
              <a:avLst/>
              <a:gdLst/>
              <a:ahLst/>
              <a:cxnLst/>
              <a:rect l="l" t="t" r="r" b="b"/>
              <a:pathLst>
                <a:path w="3861435" h="5080">
                  <a:moveTo>
                    <a:pt x="0" y="4952"/>
                  </a:moveTo>
                  <a:lnTo>
                    <a:pt x="3773042" y="4952"/>
                  </a:lnTo>
                </a:path>
                <a:path w="3861435" h="5080">
                  <a:moveTo>
                    <a:pt x="0" y="0"/>
                  </a:moveTo>
                  <a:lnTo>
                    <a:pt x="3773042" y="0"/>
                  </a:lnTo>
                </a:path>
                <a:path w="3861435" h="5080">
                  <a:moveTo>
                    <a:pt x="3842384" y="4952"/>
                  </a:moveTo>
                  <a:lnTo>
                    <a:pt x="3861434" y="4952"/>
                  </a:lnTo>
                </a:path>
                <a:path w="3861435" h="5080">
                  <a:moveTo>
                    <a:pt x="3842384" y="0"/>
                  </a:moveTo>
                  <a:lnTo>
                    <a:pt x="3861434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4" name="object 94"/>
            <p:cNvSpPr/>
            <p:nvPr/>
          </p:nvSpPr>
          <p:spPr>
            <a:xfrm>
              <a:off x="4208525" y="2825495"/>
              <a:ext cx="69850" cy="862965"/>
            </a:xfrm>
            <a:custGeom>
              <a:avLst/>
              <a:gdLst/>
              <a:ahLst/>
              <a:cxnLst/>
              <a:rect l="l" t="t" r="r" b="b"/>
              <a:pathLst>
                <a:path w="69850" h="862964">
                  <a:moveTo>
                    <a:pt x="69341" y="0"/>
                  </a:moveTo>
                  <a:lnTo>
                    <a:pt x="0" y="0"/>
                  </a:lnTo>
                  <a:lnTo>
                    <a:pt x="0" y="862584"/>
                  </a:lnTo>
                  <a:lnTo>
                    <a:pt x="69341" y="862584"/>
                  </a:lnTo>
                  <a:lnTo>
                    <a:pt x="69341" y="0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5" name="object 95"/>
            <p:cNvSpPr/>
            <p:nvPr/>
          </p:nvSpPr>
          <p:spPr>
            <a:xfrm>
              <a:off x="4850129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6"/>
            <p:cNvSpPr/>
            <p:nvPr/>
          </p:nvSpPr>
          <p:spPr>
            <a:xfrm>
              <a:off x="4780787" y="3099053"/>
              <a:ext cx="69850" cy="589280"/>
            </a:xfrm>
            <a:custGeom>
              <a:avLst/>
              <a:gdLst/>
              <a:ahLst/>
              <a:cxnLst/>
              <a:rect l="l" t="t" r="r" b="b"/>
              <a:pathLst>
                <a:path w="69850" h="589279">
                  <a:moveTo>
                    <a:pt x="69341" y="0"/>
                  </a:moveTo>
                  <a:lnTo>
                    <a:pt x="0" y="0"/>
                  </a:lnTo>
                  <a:lnTo>
                    <a:pt x="0" y="589026"/>
                  </a:lnTo>
                  <a:lnTo>
                    <a:pt x="69341" y="589026"/>
                  </a:lnTo>
                  <a:lnTo>
                    <a:pt x="69341" y="0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7" name="object 97"/>
            <p:cNvSpPr/>
            <p:nvPr/>
          </p:nvSpPr>
          <p:spPr>
            <a:xfrm>
              <a:off x="5422392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8" name="object 98"/>
            <p:cNvSpPr/>
            <p:nvPr/>
          </p:nvSpPr>
          <p:spPr>
            <a:xfrm>
              <a:off x="5353050" y="2993897"/>
              <a:ext cx="2358390" cy="757555"/>
            </a:xfrm>
            <a:custGeom>
              <a:avLst/>
              <a:gdLst/>
              <a:ahLst/>
              <a:cxnLst/>
              <a:rect l="l" t="t" r="r" b="b"/>
              <a:pathLst>
                <a:path w="2358390" h="757554">
                  <a:moveTo>
                    <a:pt x="69342" y="0"/>
                  </a:moveTo>
                  <a:lnTo>
                    <a:pt x="0" y="0"/>
                  </a:lnTo>
                  <a:lnTo>
                    <a:pt x="0" y="694182"/>
                  </a:lnTo>
                  <a:lnTo>
                    <a:pt x="69342" y="694182"/>
                  </a:lnTo>
                  <a:lnTo>
                    <a:pt x="69342" y="0"/>
                  </a:lnTo>
                  <a:close/>
                </a:path>
                <a:path w="2358390" h="757554">
                  <a:moveTo>
                    <a:pt x="641604" y="694182"/>
                  </a:moveTo>
                  <a:lnTo>
                    <a:pt x="572262" y="694182"/>
                  </a:lnTo>
                  <a:lnTo>
                    <a:pt x="572262" y="757428"/>
                  </a:lnTo>
                  <a:lnTo>
                    <a:pt x="641604" y="757428"/>
                  </a:lnTo>
                  <a:lnTo>
                    <a:pt x="641604" y="694182"/>
                  </a:lnTo>
                  <a:close/>
                </a:path>
                <a:path w="2358390" h="757554">
                  <a:moveTo>
                    <a:pt x="1213866" y="602742"/>
                  </a:moveTo>
                  <a:lnTo>
                    <a:pt x="1144524" y="602742"/>
                  </a:lnTo>
                  <a:lnTo>
                    <a:pt x="1144524" y="694182"/>
                  </a:lnTo>
                  <a:lnTo>
                    <a:pt x="1213866" y="694182"/>
                  </a:lnTo>
                  <a:lnTo>
                    <a:pt x="1213866" y="602742"/>
                  </a:lnTo>
                  <a:close/>
                </a:path>
                <a:path w="2358390" h="757554">
                  <a:moveTo>
                    <a:pt x="1786128" y="567690"/>
                  </a:moveTo>
                  <a:lnTo>
                    <a:pt x="1717548" y="567690"/>
                  </a:lnTo>
                  <a:lnTo>
                    <a:pt x="1717548" y="694182"/>
                  </a:lnTo>
                  <a:lnTo>
                    <a:pt x="1786128" y="694182"/>
                  </a:lnTo>
                  <a:lnTo>
                    <a:pt x="1786128" y="567690"/>
                  </a:lnTo>
                  <a:close/>
                </a:path>
                <a:path w="2358390" h="757554">
                  <a:moveTo>
                    <a:pt x="2358377" y="477012"/>
                  </a:moveTo>
                  <a:lnTo>
                    <a:pt x="2289810" y="477012"/>
                  </a:lnTo>
                  <a:lnTo>
                    <a:pt x="2289810" y="694182"/>
                  </a:lnTo>
                  <a:lnTo>
                    <a:pt x="2358377" y="694182"/>
                  </a:lnTo>
                  <a:lnTo>
                    <a:pt x="2358377" y="477012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9" name="object 99"/>
            <p:cNvSpPr/>
            <p:nvPr/>
          </p:nvSpPr>
          <p:spPr>
            <a:xfrm>
              <a:off x="8283701" y="3337178"/>
              <a:ext cx="19050" cy="0"/>
            </a:xfrm>
            <a:custGeom>
              <a:avLst/>
              <a:gdLst/>
              <a:ahLst/>
              <a:cxnLst/>
              <a:rect l="l" t="t" r="r" b="b"/>
              <a:pathLst>
                <a:path w="19050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100"/>
            <p:cNvSpPr/>
            <p:nvPr/>
          </p:nvSpPr>
          <p:spPr>
            <a:xfrm>
              <a:off x="8215122" y="3267455"/>
              <a:ext cx="68580" cy="421005"/>
            </a:xfrm>
            <a:custGeom>
              <a:avLst/>
              <a:gdLst/>
              <a:ahLst/>
              <a:cxnLst/>
              <a:rect l="l" t="t" r="r" b="b"/>
              <a:pathLst>
                <a:path w="68579" h="421004">
                  <a:moveTo>
                    <a:pt x="68579" y="0"/>
                  </a:moveTo>
                  <a:lnTo>
                    <a:pt x="0" y="0"/>
                  </a:lnTo>
                  <a:lnTo>
                    <a:pt x="0" y="420624"/>
                  </a:lnTo>
                  <a:lnTo>
                    <a:pt x="68579" y="420624"/>
                  </a:lnTo>
                  <a:lnTo>
                    <a:pt x="68579" y="0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1" name="object 101"/>
            <p:cNvSpPr/>
            <p:nvPr/>
          </p:nvSpPr>
          <p:spPr>
            <a:xfrm>
              <a:off x="8855964" y="3336035"/>
              <a:ext cx="19050" cy="5080"/>
            </a:xfrm>
            <a:custGeom>
              <a:avLst/>
              <a:gdLst/>
              <a:ahLst/>
              <a:cxnLst/>
              <a:rect l="l" t="t" r="r" b="b"/>
              <a:pathLst>
                <a:path w="19050" h="5079">
                  <a:moveTo>
                    <a:pt x="0" y="4952"/>
                  </a:moveTo>
                  <a:lnTo>
                    <a:pt x="19050" y="4952"/>
                  </a:lnTo>
                </a:path>
                <a:path w="19050" h="5079">
                  <a:moveTo>
                    <a:pt x="0" y="0"/>
                  </a:moveTo>
                  <a:lnTo>
                    <a:pt x="19050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2" name="object 102"/>
            <p:cNvSpPr/>
            <p:nvPr/>
          </p:nvSpPr>
          <p:spPr>
            <a:xfrm>
              <a:off x="8787384" y="3112769"/>
              <a:ext cx="68580" cy="575310"/>
            </a:xfrm>
            <a:custGeom>
              <a:avLst/>
              <a:gdLst/>
              <a:ahLst/>
              <a:cxnLst/>
              <a:rect l="l" t="t" r="r" b="b"/>
              <a:pathLst>
                <a:path w="68579" h="575310">
                  <a:moveTo>
                    <a:pt x="68579" y="0"/>
                  </a:moveTo>
                  <a:lnTo>
                    <a:pt x="0" y="0"/>
                  </a:lnTo>
                  <a:lnTo>
                    <a:pt x="0" y="575310"/>
                  </a:lnTo>
                  <a:lnTo>
                    <a:pt x="68579" y="575310"/>
                  </a:lnTo>
                  <a:lnTo>
                    <a:pt x="68579" y="0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3" name="object 103"/>
            <p:cNvSpPr/>
            <p:nvPr/>
          </p:nvSpPr>
          <p:spPr>
            <a:xfrm>
              <a:off x="9428988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5">
                  <a:moveTo>
                    <a:pt x="0" y="0"/>
                  </a:moveTo>
                  <a:lnTo>
                    <a:pt x="1828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4"/>
            <p:cNvSpPr/>
            <p:nvPr/>
          </p:nvSpPr>
          <p:spPr>
            <a:xfrm>
              <a:off x="9359646" y="3127247"/>
              <a:ext cx="69850" cy="561340"/>
            </a:xfrm>
            <a:custGeom>
              <a:avLst/>
              <a:gdLst/>
              <a:ahLst/>
              <a:cxnLst/>
              <a:rect l="l" t="t" r="r" b="b"/>
              <a:pathLst>
                <a:path w="69850" h="561339">
                  <a:moveTo>
                    <a:pt x="69342" y="0"/>
                  </a:moveTo>
                  <a:lnTo>
                    <a:pt x="0" y="0"/>
                  </a:lnTo>
                  <a:lnTo>
                    <a:pt x="0" y="560832"/>
                  </a:lnTo>
                  <a:lnTo>
                    <a:pt x="69342" y="560832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10001250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5">
                  <a:moveTo>
                    <a:pt x="0" y="0"/>
                  </a:moveTo>
                  <a:lnTo>
                    <a:pt x="18288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9931908" y="3084575"/>
              <a:ext cx="69850" cy="603885"/>
            </a:xfrm>
            <a:custGeom>
              <a:avLst/>
              <a:gdLst/>
              <a:ahLst/>
              <a:cxnLst/>
              <a:rect l="l" t="t" r="r" b="b"/>
              <a:pathLst>
                <a:path w="69850" h="603885">
                  <a:moveTo>
                    <a:pt x="69342" y="0"/>
                  </a:moveTo>
                  <a:lnTo>
                    <a:pt x="0" y="0"/>
                  </a:lnTo>
                  <a:lnTo>
                    <a:pt x="0" y="603504"/>
                  </a:lnTo>
                  <a:lnTo>
                    <a:pt x="69342" y="603504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10573512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5">
                  <a:moveTo>
                    <a:pt x="0" y="0"/>
                  </a:moveTo>
                  <a:lnTo>
                    <a:pt x="1828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10504169" y="3330701"/>
              <a:ext cx="69850" cy="357505"/>
            </a:xfrm>
            <a:custGeom>
              <a:avLst/>
              <a:gdLst/>
              <a:ahLst/>
              <a:cxnLst/>
              <a:rect l="l" t="t" r="r" b="b"/>
              <a:pathLst>
                <a:path w="69850" h="357504">
                  <a:moveTo>
                    <a:pt x="69342" y="0"/>
                  </a:moveTo>
                  <a:lnTo>
                    <a:pt x="0" y="0"/>
                  </a:lnTo>
                  <a:lnTo>
                    <a:pt x="0" y="357377"/>
                  </a:lnTo>
                  <a:lnTo>
                    <a:pt x="69342" y="357377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9" name="object 109"/>
            <p:cNvSpPr/>
            <p:nvPr/>
          </p:nvSpPr>
          <p:spPr>
            <a:xfrm>
              <a:off x="11145774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5">
                  <a:moveTo>
                    <a:pt x="0" y="0"/>
                  </a:moveTo>
                  <a:lnTo>
                    <a:pt x="1828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0" name="object 110"/>
            <p:cNvSpPr/>
            <p:nvPr/>
          </p:nvSpPr>
          <p:spPr>
            <a:xfrm>
              <a:off x="11076431" y="3268217"/>
              <a:ext cx="69850" cy="420370"/>
            </a:xfrm>
            <a:custGeom>
              <a:avLst/>
              <a:gdLst/>
              <a:ahLst/>
              <a:cxnLst/>
              <a:rect l="l" t="t" r="r" b="b"/>
              <a:pathLst>
                <a:path w="69850" h="420370">
                  <a:moveTo>
                    <a:pt x="69342" y="0"/>
                  </a:moveTo>
                  <a:lnTo>
                    <a:pt x="0" y="0"/>
                  </a:lnTo>
                  <a:lnTo>
                    <a:pt x="0" y="419862"/>
                  </a:lnTo>
                  <a:lnTo>
                    <a:pt x="69342" y="419862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1" name="object 111"/>
            <p:cNvSpPr/>
            <p:nvPr/>
          </p:nvSpPr>
          <p:spPr>
            <a:xfrm>
              <a:off x="11718036" y="3337178"/>
              <a:ext cx="18415" cy="0"/>
            </a:xfrm>
            <a:custGeom>
              <a:avLst/>
              <a:gdLst/>
              <a:ahLst/>
              <a:cxnLst/>
              <a:rect l="l" t="t" r="r" b="b"/>
              <a:pathLst>
                <a:path w="18415">
                  <a:moveTo>
                    <a:pt x="0" y="0"/>
                  </a:moveTo>
                  <a:lnTo>
                    <a:pt x="18287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12"/>
            <p:cNvSpPr/>
            <p:nvPr/>
          </p:nvSpPr>
          <p:spPr>
            <a:xfrm>
              <a:off x="11648693" y="3145535"/>
              <a:ext cx="69850" cy="542925"/>
            </a:xfrm>
            <a:custGeom>
              <a:avLst/>
              <a:gdLst/>
              <a:ahLst/>
              <a:cxnLst/>
              <a:rect l="l" t="t" r="r" b="b"/>
              <a:pathLst>
                <a:path w="69850" h="542925">
                  <a:moveTo>
                    <a:pt x="69342" y="0"/>
                  </a:moveTo>
                  <a:lnTo>
                    <a:pt x="0" y="0"/>
                  </a:lnTo>
                  <a:lnTo>
                    <a:pt x="0" y="542544"/>
                  </a:lnTo>
                  <a:lnTo>
                    <a:pt x="69342" y="542544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1D6EA9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3" name="object 113"/>
            <p:cNvSpPr/>
            <p:nvPr/>
          </p:nvSpPr>
          <p:spPr>
            <a:xfrm>
              <a:off x="862584" y="2650235"/>
              <a:ext cx="8082280" cy="1304925"/>
            </a:xfrm>
            <a:custGeom>
              <a:avLst/>
              <a:gdLst/>
              <a:ahLst/>
              <a:cxnLst/>
              <a:rect l="l" t="t" r="r" b="b"/>
              <a:pathLst>
                <a:path w="8082280" h="1304925">
                  <a:moveTo>
                    <a:pt x="69342" y="834390"/>
                  </a:moveTo>
                  <a:lnTo>
                    <a:pt x="0" y="834390"/>
                  </a:lnTo>
                  <a:lnTo>
                    <a:pt x="0" y="1037844"/>
                  </a:lnTo>
                  <a:lnTo>
                    <a:pt x="69342" y="1037844"/>
                  </a:lnTo>
                  <a:lnTo>
                    <a:pt x="69342" y="834390"/>
                  </a:lnTo>
                  <a:close/>
                </a:path>
                <a:path w="8082280" h="1304925">
                  <a:moveTo>
                    <a:pt x="641604" y="1037844"/>
                  </a:moveTo>
                  <a:lnTo>
                    <a:pt x="572262" y="1037844"/>
                  </a:lnTo>
                  <a:lnTo>
                    <a:pt x="572262" y="1066038"/>
                  </a:lnTo>
                  <a:lnTo>
                    <a:pt x="641604" y="1066038"/>
                  </a:lnTo>
                  <a:lnTo>
                    <a:pt x="641604" y="1037844"/>
                  </a:lnTo>
                  <a:close/>
                </a:path>
                <a:path w="8082280" h="1304925">
                  <a:moveTo>
                    <a:pt x="1213866" y="1037844"/>
                  </a:moveTo>
                  <a:lnTo>
                    <a:pt x="1144524" y="1037844"/>
                  </a:lnTo>
                  <a:lnTo>
                    <a:pt x="1144524" y="1213104"/>
                  </a:lnTo>
                  <a:lnTo>
                    <a:pt x="1213866" y="1213104"/>
                  </a:lnTo>
                  <a:lnTo>
                    <a:pt x="1213866" y="1037844"/>
                  </a:lnTo>
                  <a:close/>
                </a:path>
                <a:path w="8082280" h="1304925">
                  <a:moveTo>
                    <a:pt x="1786128" y="1037844"/>
                  </a:moveTo>
                  <a:lnTo>
                    <a:pt x="1716786" y="1037844"/>
                  </a:lnTo>
                  <a:lnTo>
                    <a:pt x="1716786" y="1304544"/>
                  </a:lnTo>
                  <a:lnTo>
                    <a:pt x="1786128" y="1304544"/>
                  </a:lnTo>
                  <a:lnTo>
                    <a:pt x="1786128" y="1037844"/>
                  </a:lnTo>
                  <a:close/>
                </a:path>
                <a:path w="8082280" h="1304925">
                  <a:moveTo>
                    <a:pt x="2358390" y="953262"/>
                  </a:moveTo>
                  <a:lnTo>
                    <a:pt x="2289810" y="953262"/>
                  </a:lnTo>
                  <a:lnTo>
                    <a:pt x="2289810" y="1037844"/>
                  </a:lnTo>
                  <a:lnTo>
                    <a:pt x="2358390" y="1037844"/>
                  </a:lnTo>
                  <a:lnTo>
                    <a:pt x="2358390" y="953262"/>
                  </a:lnTo>
                  <a:close/>
                </a:path>
                <a:path w="8082280" h="1304925">
                  <a:moveTo>
                    <a:pt x="2930639" y="1037844"/>
                  </a:moveTo>
                  <a:lnTo>
                    <a:pt x="2862072" y="1037844"/>
                  </a:lnTo>
                  <a:lnTo>
                    <a:pt x="2862072" y="1248156"/>
                  </a:lnTo>
                  <a:lnTo>
                    <a:pt x="2930639" y="1248156"/>
                  </a:lnTo>
                  <a:lnTo>
                    <a:pt x="2930639" y="1037844"/>
                  </a:lnTo>
                  <a:close/>
                </a:path>
                <a:path w="8082280" h="1304925">
                  <a:moveTo>
                    <a:pt x="3502901" y="0"/>
                  </a:moveTo>
                  <a:lnTo>
                    <a:pt x="3434334" y="0"/>
                  </a:lnTo>
                  <a:lnTo>
                    <a:pt x="3434334" y="1037844"/>
                  </a:lnTo>
                  <a:lnTo>
                    <a:pt x="3502901" y="1037844"/>
                  </a:lnTo>
                  <a:lnTo>
                    <a:pt x="3502901" y="0"/>
                  </a:lnTo>
                  <a:close/>
                </a:path>
                <a:path w="8082280" h="1304925">
                  <a:moveTo>
                    <a:pt x="4075163" y="133350"/>
                  </a:moveTo>
                  <a:lnTo>
                    <a:pt x="4006596" y="133350"/>
                  </a:lnTo>
                  <a:lnTo>
                    <a:pt x="4006596" y="1037844"/>
                  </a:lnTo>
                  <a:lnTo>
                    <a:pt x="4075163" y="1037844"/>
                  </a:lnTo>
                  <a:lnTo>
                    <a:pt x="4075163" y="133350"/>
                  </a:lnTo>
                  <a:close/>
                </a:path>
                <a:path w="8082280" h="1304925">
                  <a:moveTo>
                    <a:pt x="4648187" y="512064"/>
                  </a:moveTo>
                  <a:lnTo>
                    <a:pt x="4578858" y="512064"/>
                  </a:lnTo>
                  <a:lnTo>
                    <a:pt x="4578858" y="1037844"/>
                  </a:lnTo>
                  <a:lnTo>
                    <a:pt x="4648187" y="1037844"/>
                  </a:lnTo>
                  <a:lnTo>
                    <a:pt x="4648187" y="512064"/>
                  </a:lnTo>
                  <a:close/>
                </a:path>
                <a:path w="8082280" h="1304925">
                  <a:moveTo>
                    <a:pt x="5220449" y="1037844"/>
                  </a:moveTo>
                  <a:lnTo>
                    <a:pt x="5151120" y="1037844"/>
                  </a:lnTo>
                  <a:lnTo>
                    <a:pt x="5151120" y="1114806"/>
                  </a:lnTo>
                  <a:lnTo>
                    <a:pt x="5220449" y="1114806"/>
                  </a:lnTo>
                  <a:lnTo>
                    <a:pt x="5220449" y="1037844"/>
                  </a:lnTo>
                  <a:close/>
                </a:path>
                <a:path w="8082280" h="1304925">
                  <a:moveTo>
                    <a:pt x="5792724" y="778002"/>
                  </a:moveTo>
                  <a:lnTo>
                    <a:pt x="5723382" y="778002"/>
                  </a:lnTo>
                  <a:lnTo>
                    <a:pt x="5723382" y="1037844"/>
                  </a:lnTo>
                  <a:lnTo>
                    <a:pt x="5792724" y="1037844"/>
                  </a:lnTo>
                  <a:lnTo>
                    <a:pt x="5792724" y="778002"/>
                  </a:lnTo>
                  <a:close/>
                </a:path>
                <a:path w="8082280" h="1304925">
                  <a:moveTo>
                    <a:pt x="6364986" y="1037844"/>
                  </a:moveTo>
                  <a:lnTo>
                    <a:pt x="6295644" y="1037844"/>
                  </a:lnTo>
                  <a:lnTo>
                    <a:pt x="6295644" y="1058418"/>
                  </a:lnTo>
                  <a:lnTo>
                    <a:pt x="6364986" y="1058418"/>
                  </a:lnTo>
                  <a:lnTo>
                    <a:pt x="6364986" y="1037844"/>
                  </a:lnTo>
                  <a:close/>
                </a:path>
                <a:path w="8082280" h="1304925">
                  <a:moveTo>
                    <a:pt x="6937248" y="357378"/>
                  </a:moveTo>
                  <a:lnTo>
                    <a:pt x="6867906" y="357378"/>
                  </a:lnTo>
                  <a:lnTo>
                    <a:pt x="6867906" y="1037844"/>
                  </a:lnTo>
                  <a:lnTo>
                    <a:pt x="6937248" y="1037844"/>
                  </a:lnTo>
                  <a:lnTo>
                    <a:pt x="6937248" y="357378"/>
                  </a:lnTo>
                  <a:close/>
                </a:path>
                <a:path w="8082280" h="1304925">
                  <a:moveTo>
                    <a:pt x="7509510" y="672846"/>
                  </a:moveTo>
                  <a:lnTo>
                    <a:pt x="7440168" y="672846"/>
                  </a:lnTo>
                  <a:lnTo>
                    <a:pt x="7440168" y="1037856"/>
                  </a:lnTo>
                  <a:lnTo>
                    <a:pt x="7509510" y="1037856"/>
                  </a:lnTo>
                  <a:lnTo>
                    <a:pt x="7509510" y="672846"/>
                  </a:lnTo>
                  <a:close/>
                </a:path>
                <a:path w="8082280" h="1304925">
                  <a:moveTo>
                    <a:pt x="8081772" y="595884"/>
                  </a:moveTo>
                  <a:lnTo>
                    <a:pt x="8012430" y="595884"/>
                  </a:lnTo>
                  <a:lnTo>
                    <a:pt x="8012430" y="1037856"/>
                  </a:lnTo>
                  <a:lnTo>
                    <a:pt x="8081772" y="1037856"/>
                  </a:lnTo>
                  <a:lnTo>
                    <a:pt x="8081772" y="595884"/>
                  </a:lnTo>
                  <a:close/>
                </a:path>
              </a:pathLst>
            </a:custGeom>
            <a:solidFill>
              <a:srgbClr val="B7481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4" name="object 114"/>
            <p:cNvSpPr/>
            <p:nvPr/>
          </p:nvSpPr>
          <p:spPr>
            <a:xfrm>
              <a:off x="9516617" y="2985515"/>
              <a:ext cx="2365375" cy="5080"/>
            </a:xfrm>
            <a:custGeom>
              <a:avLst/>
              <a:gdLst/>
              <a:ahLst/>
              <a:cxnLst/>
              <a:rect l="l" t="t" r="r" b="b"/>
              <a:pathLst>
                <a:path w="2365375" h="5080">
                  <a:moveTo>
                    <a:pt x="0" y="4952"/>
                  </a:moveTo>
                  <a:lnTo>
                    <a:pt x="2364866" y="4952"/>
                  </a:lnTo>
                </a:path>
                <a:path w="2365375" h="5080">
                  <a:moveTo>
                    <a:pt x="0" y="0"/>
                  </a:moveTo>
                  <a:lnTo>
                    <a:pt x="2364866" y="0"/>
                  </a:lnTo>
                </a:path>
              </a:pathLst>
            </a:custGeom>
            <a:ln w="317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5" name="object 115"/>
            <p:cNvSpPr/>
            <p:nvPr/>
          </p:nvSpPr>
          <p:spPr>
            <a:xfrm>
              <a:off x="9447276" y="2769107"/>
              <a:ext cx="1786255" cy="919480"/>
            </a:xfrm>
            <a:custGeom>
              <a:avLst/>
              <a:gdLst/>
              <a:ahLst/>
              <a:cxnLst/>
              <a:rect l="l" t="t" r="r" b="b"/>
              <a:pathLst>
                <a:path w="1786254" h="919479">
                  <a:moveTo>
                    <a:pt x="69342" y="0"/>
                  </a:moveTo>
                  <a:lnTo>
                    <a:pt x="0" y="0"/>
                  </a:lnTo>
                  <a:lnTo>
                    <a:pt x="0" y="918984"/>
                  </a:lnTo>
                  <a:lnTo>
                    <a:pt x="69342" y="918984"/>
                  </a:lnTo>
                  <a:lnTo>
                    <a:pt x="69342" y="0"/>
                  </a:lnTo>
                  <a:close/>
                </a:path>
                <a:path w="1786254" h="919479">
                  <a:moveTo>
                    <a:pt x="641604" y="483870"/>
                  </a:moveTo>
                  <a:lnTo>
                    <a:pt x="572262" y="483870"/>
                  </a:lnTo>
                  <a:lnTo>
                    <a:pt x="572262" y="918972"/>
                  </a:lnTo>
                  <a:lnTo>
                    <a:pt x="641604" y="918972"/>
                  </a:lnTo>
                  <a:lnTo>
                    <a:pt x="641604" y="483870"/>
                  </a:lnTo>
                  <a:close/>
                </a:path>
                <a:path w="1786254" h="919479">
                  <a:moveTo>
                    <a:pt x="1213866" y="288036"/>
                  </a:moveTo>
                  <a:lnTo>
                    <a:pt x="1144524" y="288036"/>
                  </a:lnTo>
                  <a:lnTo>
                    <a:pt x="1144524" y="918984"/>
                  </a:lnTo>
                  <a:lnTo>
                    <a:pt x="1213866" y="918984"/>
                  </a:lnTo>
                  <a:lnTo>
                    <a:pt x="1213866" y="288036"/>
                  </a:lnTo>
                  <a:close/>
                </a:path>
                <a:path w="1786254" h="919479">
                  <a:moveTo>
                    <a:pt x="1786128" y="410718"/>
                  </a:moveTo>
                  <a:lnTo>
                    <a:pt x="1716786" y="410718"/>
                  </a:lnTo>
                  <a:lnTo>
                    <a:pt x="1716786" y="918972"/>
                  </a:lnTo>
                  <a:lnTo>
                    <a:pt x="1786128" y="918972"/>
                  </a:lnTo>
                  <a:lnTo>
                    <a:pt x="1786128" y="410718"/>
                  </a:lnTo>
                  <a:close/>
                </a:path>
              </a:pathLst>
            </a:custGeom>
            <a:solidFill>
              <a:srgbClr val="B7481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6"/>
            <p:cNvSpPr/>
            <p:nvPr/>
          </p:nvSpPr>
          <p:spPr>
            <a:xfrm>
              <a:off x="11805665" y="3337178"/>
              <a:ext cx="76200" cy="0"/>
            </a:xfrm>
            <a:custGeom>
              <a:avLst/>
              <a:gdLst/>
              <a:ahLst/>
              <a:cxnLst/>
              <a:rect l="l" t="t" r="r" b="b"/>
              <a:pathLst>
                <a:path w="76200">
                  <a:moveTo>
                    <a:pt x="0" y="0"/>
                  </a:moveTo>
                  <a:lnTo>
                    <a:pt x="75818" y="0"/>
                  </a:lnTo>
                </a:path>
              </a:pathLst>
            </a:custGeom>
            <a:ln w="9905">
              <a:solidFill>
                <a:srgbClr val="D9D9D9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7" name="object 117"/>
            <p:cNvSpPr/>
            <p:nvPr/>
          </p:nvSpPr>
          <p:spPr>
            <a:xfrm>
              <a:off x="11736324" y="3028187"/>
              <a:ext cx="69850" cy="660400"/>
            </a:xfrm>
            <a:custGeom>
              <a:avLst/>
              <a:gdLst/>
              <a:ahLst/>
              <a:cxnLst/>
              <a:rect l="l" t="t" r="r" b="b"/>
              <a:pathLst>
                <a:path w="69850" h="660400">
                  <a:moveTo>
                    <a:pt x="69342" y="0"/>
                  </a:moveTo>
                  <a:lnTo>
                    <a:pt x="0" y="0"/>
                  </a:lnTo>
                  <a:lnTo>
                    <a:pt x="0" y="659892"/>
                  </a:lnTo>
                  <a:lnTo>
                    <a:pt x="69342" y="659892"/>
                  </a:lnTo>
                  <a:lnTo>
                    <a:pt x="69342" y="0"/>
                  </a:lnTo>
                  <a:close/>
                </a:path>
              </a:pathLst>
            </a:custGeom>
            <a:solidFill>
              <a:srgbClr val="B7481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8" name="object 118"/>
          <p:cNvSpPr/>
          <p:nvPr/>
        </p:nvSpPr>
        <p:spPr>
          <a:xfrm>
            <a:off x="435483" y="2285619"/>
            <a:ext cx="11446510" cy="0"/>
          </a:xfrm>
          <a:custGeom>
            <a:avLst/>
            <a:gdLst/>
            <a:ahLst/>
            <a:cxnLst/>
            <a:rect l="l" t="t" r="r" b="b"/>
            <a:pathLst>
              <a:path w="11446510">
                <a:moveTo>
                  <a:pt x="0" y="0"/>
                </a:moveTo>
                <a:lnTo>
                  <a:pt x="11446002" y="0"/>
                </a:lnTo>
              </a:path>
            </a:pathLst>
          </a:custGeom>
          <a:ln w="9906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9" name="object 119"/>
          <p:cNvSpPr txBox="1"/>
          <p:nvPr/>
        </p:nvSpPr>
        <p:spPr>
          <a:xfrm>
            <a:off x="137140" y="2191387"/>
            <a:ext cx="205740" cy="226631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2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580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1.5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580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1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585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0.5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580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0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585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-</a:t>
            </a:r>
            <a:r>
              <a:rPr sz="900" spc="-5" dirty="0">
                <a:solidFill>
                  <a:srgbClr val="585858"/>
                </a:solidFill>
                <a:latin typeface="Calibri"/>
                <a:cs typeface="Calibri"/>
              </a:rPr>
              <a:t>0</a:t>
            </a: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.5</a:t>
            </a:r>
            <a:endParaRPr sz="900">
              <a:latin typeface="Calibri"/>
              <a:cs typeface="Calibri"/>
            </a:endParaRPr>
          </a:p>
          <a:p>
            <a:pPr>
              <a:lnSpc>
                <a:spcPct val="100000"/>
              </a:lnSpc>
            </a:pPr>
            <a:endParaRPr sz="900">
              <a:latin typeface="Calibri"/>
              <a:cs typeface="Calibri"/>
            </a:endParaRPr>
          </a:p>
          <a:p>
            <a:pPr marR="5080" algn="r">
              <a:lnSpc>
                <a:spcPct val="100000"/>
              </a:lnSpc>
              <a:spcBef>
                <a:spcPts val="580"/>
              </a:spcBef>
            </a:pPr>
            <a:r>
              <a:rPr sz="900" dirty="0">
                <a:solidFill>
                  <a:srgbClr val="585858"/>
                </a:solidFill>
                <a:latin typeface="Calibri"/>
                <a:cs typeface="Calibri"/>
              </a:rPr>
              <a:t>-1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20" name="object 120"/>
          <p:cNvSpPr/>
          <p:nvPr/>
        </p:nvSpPr>
        <p:spPr>
          <a:xfrm>
            <a:off x="3275838" y="4596384"/>
            <a:ext cx="112395" cy="112395"/>
          </a:xfrm>
          <a:custGeom>
            <a:avLst/>
            <a:gdLst/>
            <a:ahLst/>
            <a:cxnLst/>
            <a:rect l="l" t="t" r="r" b="b"/>
            <a:pathLst>
              <a:path w="112395" h="112395">
                <a:moveTo>
                  <a:pt x="112013" y="0"/>
                </a:moveTo>
                <a:lnTo>
                  <a:pt x="0" y="0"/>
                </a:lnTo>
                <a:lnTo>
                  <a:pt x="0" y="112014"/>
                </a:lnTo>
                <a:lnTo>
                  <a:pt x="112013" y="112014"/>
                </a:lnTo>
                <a:lnTo>
                  <a:pt x="112013" y="0"/>
                </a:lnTo>
                <a:close/>
              </a:path>
            </a:pathLst>
          </a:custGeom>
          <a:solidFill>
            <a:srgbClr val="1D9A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1" name="object 121"/>
          <p:cNvSpPr txBox="1"/>
          <p:nvPr/>
        </p:nvSpPr>
        <p:spPr>
          <a:xfrm>
            <a:off x="3426118" y="4494446"/>
            <a:ext cx="883919" cy="2698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600" spc="-5" dirty="0">
                <a:solidFill>
                  <a:srgbClr val="585858"/>
                </a:solidFill>
                <a:latin typeface="Calibri"/>
                <a:cs typeface="Calibri"/>
              </a:rPr>
              <a:t>MIR7-3HG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22" name="object 122"/>
          <p:cNvSpPr/>
          <p:nvPr/>
        </p:nvSpPr>
        <p:spPr>
          <a:xfrm>
            <a:off x="4527803" y="4596384"/>
            <a:ext cx="112395" cy="112395"/>
          </a:xfrm>
          <a:custGeom>
            <a:avLst/>
            <a:gdLst/>
            <a:ahLst/>
            <a:cxnLst/>
            <a:rect l="l" t="t" r="r" b="b"/>
            <a:pathLst>
              <a:path w="112395" h="112395">
                <a:moveTo>
                  <a:pt x="112013" y="0"/>
                </a:moveTo>
                <a:lnTo>
                  <a:pt x="0" y="0"/>
                </a:lnTo>
                <a:lnTo>
                  <a:pt x="0" y="112014"/>
                </a:lnTo>
                <a:lnTo>
                  <a:pt x="112013" y="112014"/>
                </a:lnTo>
                <a:lnTo>
                  <a:pt x="112013" y="0"/>
                </a:lnTo>
                <a:close/>
              </a:path>
            </a:pathLst>
          </a:custGeom>
          <a:solidFill>
            <a:srgbClr val="8AC14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3" name="object 123"/>
          <p:cNvSpPr txBox="1"/>
          <p:nvPr/>
        </p:nvSpPr>
        <p:spPr>
          <a:xfrm>
            <a:off x="4678083" y="4494446"/>
            <a:ext cx="669925" cy="2698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600" spc="-5" dirty="0">
                <a:solidFill>
                  <a:srgbClr val="585858"/>
                </a:solidFill>
                <a:latin typeface="Calibri"/>
                <a:cs typeface="Calibri"/>
              </a:rPr>
              <a:t>MI</a:t>
            </a:r>
            <a:r>
              <a:rPr sz="1600" dirty="0">
                <a:solidFill>
                  <a:srgbClr val="585858"/>
                </a:solidFill>
                <a:latin typeface="Calibri"/>
                <a:cs typeface="Calibri"/>
              </a:rPr>
              <a:t>R</a:t>
            </a:r>
            <a:r>
              <a:rPr sz="1600" spc="-5" dirty="0">
                <a:solidFill>
                  <a:srgbClr val="585858"/>
                </a:solidFill>
                <a:latin typeface="Calibri"/>
                <a:cs typeface="Calibri"/>
              </a:rPr>
              <a:t>488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24" name="object 124"/>
          <p:cNvSpPr/>
          <p:nvPr/>
        </p:nvSpPr>
        <p:spPr>
          <a:xfrm>
            <a:off x="5566409" y="4596384"/>
            <a:ext cx="111760" cy="112395"/>
          </a:xfrm>
          <a:custGeom>
            <a:avLst/>
            <a:gdLst/>
            <a:ahLst/>
            <a:cxnLst/>
            <a:rect l="l" t="t" r="r" b="b"/>
            <a:pathLst>
              <a:path w="111760" h="112395">
                <a:moveTo>
                  <a:pt x="111251" y="0"/>
                </a:moveTo>
                <a:lnTo>
                  <a:pt x="0" y="0"/>
                </a:lnTo>
                <a:lnTo>
                  <a:pt x="0" y="112014"/>
                </a:lnTo>
                <a:lnTo>
                  <a:pt x="111251" y="112014"/>
                </a:lnTo>
                <a:lnTo>
                  <a:pt x="111251" y="0"/>
                </a:lnTo>
                <a:close/>
              </a:path>
            </a:pathLst>
          </a:custGeom>
          <a:solidFill>
            <a:srgbClr val="36AEC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5" name="object 125"/>
          <p:cNvSpPr txBox="1"/>
          <p:nvPr/>
        </p:nvSpPr>
        <p:spPr>
          <a:xfrm>
            <a:off x="5715987" y="4494446"/>
            <a:ext cx="1113155" cy="2698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600" spc="-5" dirty="0">
                <a:solidFill>
                  <a:srgbClr val="585858"/>
                </a:solidFill>
                <a:latin typeface="Calibri"/>
                <a:cs typeface="Calibri"/>
              </a:rPr>
              <a:t>MIRLET7BHG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26" name="object 126"/>
          <p:cNvSpPr/>
          <p:nvPr/>
        </p:nvSpPr>
        <p:spPr>
          <a:xfrm>
            <a:off x="7046976" y="4596384"/>
            <a:ext cx="111760" cy="112395"/>
          </a:xfrm>
          <a:custGeom>
            <a:avLst/>
            <a:gdLst/>
            <a:ahLst/>
            <a:cxnLst/>
            <a:rect l="l" t="t" r="r" b="b"/>
            <a:pathLst>
              <a:path w="111759" h="112395">
                <a:moveTo>
                  <a:pt x="111251" y="0"/>
                </a:moveTo>
                <a:lnTo>
                  <a:pt x="0" y="0"/>
                </a:lnTo>
                <a:lnTo>
                  <a:pt x="0" y="112014"/>
                </a:lnTo>
                <a:lnTo>
                  <a:pt x="111251" y="112014"/>
                </a:lnTo>
                <a:lnTo>
                  <a:pt x="111251" y="0"/>
                </a:lnTo>
                <a:close/>
              </a:path>
            </a:pathLst>
          </a:custGeom>
          <a:solidFill>
            <a:srgbClr val="1D6EA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7" name="object 127"/>
          <p:cNvSpPr txBox="1"/>
          <p:nvPr/>
        </p:nvSpPr>
        <p:spPr>
          <a:xfrm>
            <a:off x="7196933" y="4494446"/>
            <a:ext cx="669925" cy="2698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600" spc="-5" dirty="0">
                <a:solidFill>
                  <a:srgbClr val="585858"/>
                </a:solidFill>
                <a:latin typeface="Calibri"/>
                <a:cs typeface="Calibri"/>
              </a:rPr>
              <a:t>MI</a:t>
            </a:r>
            <a:r>
              <a:rPr sz="1600" dirty="0">
                <a:solidFill>
                  <a:srgbClr val="585858"/>
                </a:solidFill>
                <a:latin typeface="Calibri"/>
                <a:cs typeface="Calibri"/>
              </a:rPr>
              <a:t>R</a:t>
            </a:r>
            <a:r>
              <a:rPr sz="1600" spc="-5" dirty="0">
                <a:solidFill>
                  <a:srgbClr val="585858"/>
                </a:solidFill>
                <a:latin typeface="Calibri"/>
                <a:cs typeface="Calibri"/>
              </a:rPr>
              <a:t>607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28" name="object 128"/>
          <p:cNvSpPr/>
          <p:nvPr/>
        </p:nvSpPr>
        <p:spPr>
          <a:xfrm>
            <a:off x="8084819" y="4596384"/>
            <a:ext cx="112395" cy="112395"/>
          </a:xfrm>
          <a:custGeom>
            <a:avLst/>
            <a:gdLst/>
            <a:ahLst/>
            <a:cxnLst/>
            <a:rect l="l" t="t" r="r" b="b"/>
            <a:pathLst>
              <a:path w="112395" h="112395">
                <a:moveTo>
                  <a:pt x="112014" y="0"/>
                </a:moveTo>
                <a:lnTo>
                  <a:pt x="0" y="0"/>
                </a:lnTo>
                <a:lnTo>
                  <a:pt x="0" y="112014"/>
                </a:lnTo>
                <a:lnTo>
                  <a:pt x="112014" y="112014"/>
                </a:lnTo>
                <a:lnTo>
                  <a:pt x="112014" y="0"/>
                </a:lnTo>
                <a:close/>
              </a:path>
            </a:pathLst>
          </a:custGeom>
          <a:solidFill>
            <a:srgbClr val="B7481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9" name="object 129"/>
          <p:cNvSpPr txBox="1"/>
          <p:nvPr/>
        </p:nvSpPr>
        <p:spPr>
          <a:xfrm>
            <a:off x="8234838" y="4494446"/>
            <a:ext cx="788035" cy="2698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600" spc="-5" dirty="0">
                <a:solidFill>
                  <a:srgbClr val="585858"/>
                </a:solidFill>
                <a:latin typeface="Calibri"/>
                <a:cs typeface="Calibri"/>
              </a:rPr>
              <a:t>MIR130A</a:t>
            </a:r>
            <a:endParaRPr sz="1600">
              <a:latin typeface="Calibri"/>
              <a:cs typeface="Calibri"/>
            </a:endParaRPr>
          </a:p>
        </p:txBody>
      </p:sp>
      <p:sp>
        <p:nvSpPr>
          <p:cNvPr id="130" name="object 130"/>
          <p:cNvSpPr/>
          <p:nvPr/>
        </p:nvSpPr>
        <p:spPr>
          <a:xfrm>
            <a:off x="557022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1" name="object 131"/>
          <p:cNvSpPr/>
          <p:nvPr/>
        </p:nvSpPr>
        <p:spPr>
          <a:xfrm>
            <a:off x="1106424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1655826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3" name="object 133"/>
          <p:cNvSpPr/>
          <p:nvPr/>
        </p:nvSpPr>
        <p:spPr>
          <a:xfrm>
            <a:off x="2242566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4" name="object 134"/>
          <p:cNvSpPr/>
          <p:nvPr/>
        </p:nvSpPr>
        <p:spPr>
          <a:xfrm>
            <a:off x="2810255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5" name="object 135"/>
          <p:cNvSpPr/>
          <p:nvPr/>
        </p:nvSpPr>
        <p:spPr>
          <a:xfrm>
            <a:off x="3350514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6" name="object 136"/>
          <p:cNvSpPr/>
          <p:nvPr/>
        </p:nvSpPr>
        <p:spPr>
          <a:xfrm>
            <a:off x="3928109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" name="object 137"/>
          <p:cNvSpPr/>
          <p:nvPr/>
        </p:nvSpPr>
        <p:spPr>
          <a:xfrm>
            <a:off x="4533138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8" name="object 138"/>
          <p:cNvSpPr/>
          <p:nvPr/>
        </p:nvSpPr>
        <p:spPr>
          <a:xfrm>
            <a:off x="5082540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9" name="object 139"/>
          <p:cNvSpPr/>
          <p:nvPr/>
        </p:nvSpPr>
        <p:spPr>
          <a:xfrm>
            <a:off x="5678423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0" name="object 140"/>
          <p:cNvSpPr/>
          <p:nvPr/>
        </p:nvSpPr>
        <p:spPr>
          <a:xfrm>
            <a:off x="6227826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1" name="object 141"/>
          <p:cNvSpPr/>
          <p:nvPr/>
        </p:nvSpPr>
        <p:spPr>
          <a:xfrm>
            <a:off x="6777228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2" name="object 142"/>
          <p:cNvSpPr/>
          <p:nvPr/>
        </p:nvSpPr>
        <p:spPr>
          <a:xfrm>
            <a:off x="7363968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3" name="object 143"/>
          <p:cNvSpPr/>
          <p:nvPr/>
        </p:nvSpPr>
        <p:spPr>
          <a:xfrm>
            <a:off x="7950707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4" name="object 144"/>
          <p:cNvSpPr/>
          <p:nvPr/>
        </p:nvSpPr>
        <p:spPr>
          <a:xfrm>
            <a:off x="8536685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9100566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9668256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10236707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10844021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11426952" y="2215895"/>
            <a:ext cx="425450" cy="0"/>
          </a:xfrm>
          <a:custGeom>
            <a:avLst/>
            <a:gdLst/>
            <a:ahLst/>
            <a:cxnLst/>
            <a:rect l="l" t="t" r="r" b="b"/>
            <a:pathLst>
              <a:path w="425450">
                <a:moveTo>
                  <a:pt x="0" y="0"/>
                </a:moveTo>
                <a:lnTo>
                  <a:pt x="424865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0" name="object 150"/>
          <p:cNvSpPr txBox="1"/>
          <p:nvPr/>
        </p:nvSpPr>
        <p:spPr>
          <a:xfrm>
            <a:off x="1240354" y="1626961"/>
            <a:ext cx="14351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P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51" name="object 151"/>
          <p:cNvSpPr txBox="1"/>
          <p:nvPr/>
        </p:nvSpPr>
        <p:spPr>
          <a:xfrm>
            <a:off x="2889017" y="1626961"/>
            <a:ext cx="34036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Calibri"/>
                <a:cs typeface="Calibri"/>
              </a:rPr>
              <a:t>WT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52" name="object 152"/>
          <p:cNvSpPr txBox="1"/>
          <p:nvPr/>
        </p:nvSpPr>
        <p:spPr>
          <a:xfrm>
            <a:off x="4611289" y="1615531"/>
            <a:ext cx="26352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5" dirty="0">
                <a:latin typeface="Calibri"/>
                <a:cs typeface="Calibri"/>
              </a:rPr>
              <a:t>C1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53" name="object 153"/>
          <p:cNvSpPr txBox="1"/>
          <p:nvPr/>
        </p:nvSpPr>
        <p:spPr>
          <a:xfrm>
            <a:off x="6296757" y="1604101"/>
            <a:ext cx="28511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5" dirty="0">
                <a:latin typeface="Calibri"/>
                <a:cs typeface="Calibri"/>
              </a:rPr>
              <a:t>G2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54" name="object 154"/>
          <p:cNvSpPr txBox="1"/>
          <p:nvPr/>
        </p:nvSpPr>
        <p:spPr>
          <a:xfrm>
            <a:off x="8028402" y="1592671"/>
            <a:ext cx="28384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5" dirty="0">
                <a:latin typeface="Calibri"/>
                <a:cs typeface="Calibri"/>
              </a:rPr>
              <a:t>H</a:t>
            </a:r>
            <a:r>
              <a:rPr sz="1800" dirty="0">
                <a:latin typeface="Calibri"/>
                <a:cs typeface="Calibri"/>
              </a:rPr>
              <a:t>2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55" name="object 155"/>
          <p:cNvSpPr txBox="1"/>
          <p:nvPr/>
        </p:nvSpPr>
        <p:spPr>
          <a:xfrm>
            <a:off x="9760047" y="1581241"/>
            <a:ext cx="28384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5" dirty="0">
                <a:latin typeface="Calibri"/>
                <a:cs typeface="Calibri"/>
              </a:rPr>
              <a:t>H</a:t>
            </a:r>
            <a:r>
              <a:rPr sz="1800" dirty="0">
                <a:latin typeface="Calibri"/>
                <a:cs typeface="Calibri"/>
              </a:rPr>
              <a:t>8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56" name="object 156"/>
          <p:cNvSpPr/>
          <p:nvPr/>
        </p:nvSpPr>
        <p:spPr>
          <a:xfrm>
            <a:off x="11470016" y="1427360"/>
            <a:ext cx="664331" cy="562020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7" name="object 157"/>
          <p:cNvSpPr txBox="1"/>
          <p:nvPr/>
        </p:nvSpPr>
        <p:spPr>
          <a:xfrm>
            <a:off x="10885577" y="1769313"/>
            <a:ext cx="33718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35" dirty="0">
                <a:latin typeface="Calibri"/>
                <a:cs typeface="Calibri"/>
              </a:rPr>
              <a:t>A</a:t>
            </a:r>
            <a:r>
              <a:rPr sz="1800" dirty="0">
                <a:latin typeface="Calibri"/>
                <a:cs typeface="Calibri"/>
              </a:rPr>
              <a:t>vr</a:t>
            </a:r>
            <a:endParaRPr sz="1800">
              <a:latin typeface="Calibri"/>
              <a:cs typeface="Calibri"/>
            </a:endParaRPr>
          </a:p>
        </p:txBody>
      </p:sp>
      <p:sp>
        <p:nvSpPr>
          <p:cNvPr id="158" name="object 158"/>
          <p:cNvSpPr/>
          <p:nvPr/>
        </p:nvSpPr>
        <p:spPr>
          <a:xfrm>
            <a:off x="735330" y="1959101"/>
            <a:ext cx="1272540" cy="155575"/>
          </a:xfrm>
          <a:custGeom>
            <a:avLst/>
            <a:gdLst/>
            <a:ahLst/>
            <a:cxnLst/>
            <a:rect l="l" t="t" r="r" b="b"/>
            <a:pathLst>
              <a:path w="1272539" h="155575">
                <a:moveTo>
                  <a:pt x="0" y="155448"/>
                </a:moveTo>
                <a:lnTo>
                  <a:pt x="1018" y="94940"/>
                </a:lnTo>
                <a:lnTo>
                  <a:pt x="3795" y="45529"/>
                </a:lnTo>
                <a:lnTo>
                  <a:pt x="7913" y="12215"/>
                </a:lnTo>
                <a:lnTo>
                  <a:pt x="12954" y="0"/>
                </a:lnTo>
                <a:lnTo>
                  <a:pt x="1259586" y="0"/>
                </a:lnTo>
                <a:lnTo>
                  <a:pt x="1264626" y="12215"/>
                </a:lnTo>
                <a:lnTo>
                  <a:pt x="1268744" y="45529"/>
                </a:lnTo>
                <a:lnTo>
                  <a:pt x="1271521" y="94940"/>
                </a:lnTo>
                <a:lnTo>
                  <a:pt x="1272540" y="155448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9" name="object 159"/>
          <p:cNvSpPr/>
          <p:nvPr/>
        </p:nvSpPr>
        <p:spPr>
          <a:xfrm>
            <a:off x="2379726" y="1960626"/>
            <a:ext cx="1272540" cy="156210"/>
          </a:xfrm>
          <a:custGeom>
            <a:avLst/>
            <a:gdLst/>
            <a:ahLst/>
            <a:cxnLst/>
            <a:rect l="l" t="t" r="r" b="b"/>
            <a:pathLst>
              <a:path w="1272539" h="156210">
                <a:moveTo>
                  <a:pt x="0" y="156210"/>
                </a:moveTo>
                <a:lnTo>
                  <a:pt x="1023" y="95406"/>
                </a:lnTo>
                <a:lnTo>
                  <a:pt x="3813" y="45753"/>
                </a:lnTo>
                <a:lnTo>
                  <a:pt x="7950" y="12275"/>
                </a:lnTo>
                <a:lnTo>
                  <a:pt x="13017" y="0"/>
                </a:lnTo>
                <a:lnTo>
                  <a:pt x="1259522" y="0"/>
                </a:lnTo>
                <a:lnTo>
                  <a:pt x="1264589" y="12275"/>
                </a:lnTo>
                <a:lnTo>
                  <a:pt x="1268726" y="45753"/>
                </a:lnTo>
                <a:lnTo>
                  <a:pt x="1271516" y="95406"/>
                </a:lnTo>
                <a:lnTo>
                  <a:pt x="1272540" y="156210"/>
                </a:lnTo>
              </a:path>
            </a:pathLst>
          </a:custGeom>
          <a:ln w="609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0" name="object 160"/>
          <p:cNvSpPr/>
          <p:nvPr/>
        </p:nvSpPr>
        <p:spPr>
          <a:xfrm>
            <a:off x="4098797" y="1943861"/>
            <a:ext cx="1272540" cy="155575"/>
          </a:xfrm>
          <a:custGeom>
            <a:avLst/>
            <a:gdLst/>
            <a:ahLst/>
            <a:cxnLst/>
            <a:rect l="l" t="t" r="r" b="b"/>
            <a:pathLst>
              <a:path w="1272539" h="155575">
                <a:moveTo>
                  <a:pt x="0" y="155448"/>
                </a:moveTo>
                <a:lnTo>
                  <a:pt x="1018" y="94940"/>
                </a:lnTo>
                <a:lnTo>
                  <a:pt x="3795" y="45529"/>
                </a:lnTo>
                <a:lnTo>
                  <a:pt x="7913" y="12215"/>
                </a:lnTo>
                <a:lnTo>
                  <a:pt x="12954" y="0"/>
                </a:lnTo>
                <a:lnTo>
                  <a:pt x="1259586" y="0"/>
                </a:lnTo>
                <a:lnTo>
                  <a:pt x="1264626" y="12215"/>
                </a:lnTo>
                <a:lnTo>
                  <a:pt x="1268744" y="45529"/>
                </a:lnTo>
                <a:lnTo>
                  <a:pt x="1271521" y="94940"/>
                </a:lnTo>
                <a:lnTo>
                  <a:pt x="1272540" y="155448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1" name="object 161"/>
          <p:cNvSpPr/>
          <p:nvPr/>
        </p:nvSpPr>
        <p:spPr>
          <a:xfrm>
            <a:off x="5752338" y="1943861"/>
            <a:ext cx="1272540" cy="155575"/>
          </a:xfrm>
          <a:custGeom>
            <a:avLst/>
            <a:gdLst/>
            <a:ahLst/>
            <a:cxnLst/>
            <a:rect l="l" t="t" r="r" b="b"/>
            <a:pathLst>
              <a:path w="1272540" h="155575">
                <a:moveTo>
                  <a:pt x="0" y="155448"/>
                </a:moveTo>
                <a:lnTo>
                  <a:pt x="1018" y="94940"/>
                </a:lnTo>
                <a:lnTo>
                  <a:pt x="3795" y="45529"/>
                </a:lnTo>
                <a:lnTo>
                  <a:pt x="7913" y="12215"/>
                </a:lnTo>
                <a:lnTo>
                  <a:pt x="12954" y="0"/>
                </a:lnTo>
                <a:lnTo>
                  <a:pt x="1259586" y="0"/>
                </a:lnTo>
                <a:lnTo>
                  <a:pt x="1264626" y="12215"/>
                </a:lnTo>
                <a:lnTo>
                  <a:pt x="1268744" y="45529"/>
                </a:lnTo>
                <a:lnTo>
                  <a:pt x="1271521" y="94940"/>
                </a:lnTo>
                <a:lnTo>
                  <a:pt x="1272540" y="155448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2" name="object 162"/>
          <p:cNvSpPr/>
          <p:nvPr/>
        </p:nvSpPr>
        <p:spPr>
          <a:xfrm>
            <a:off x="7511795" y="1929383"/>
            <a:ext cx="1272540" cy="155575"/>
          </a:xfrm>
          <a:custGeom>
            <a:avLst/>
            <a:gdLst/>
            <a:ahLst/>
            <a:cxnLst/>
            <a:rect l="l" t="t" r="r" b="b"/>
            <a:pathLst>
              <a:path w="1272540" h="155575">
                <a:moveTo>
                  <a:pt x="0" y="155448"/>
                </a:moveTo>
                <a:lnTo>
                  <a:pt x="1018" y="94940"/>
                </a:lnTo>
                <a:lnTo>
                  <a:pt x="3795" y="45529"/>
                </a:lnTo>
                <a:lnTo>
                  <a:pt x="7913" y="12215"/>
                </a:lnTo>
                <a:lnTo>
                  <a:pt x="12954" y="0"/>
                </a:lnTo>
                <a:lnTo>
                  <a:pt x="1259586" y="0"/>
                </a:lnTo>
                <a:lnTo>
                  <a:pt x="1264626" y="12215"/>
                </a:lnTo>
                <a:lnTo>
                  <a:pt x="1268744" y="45529"/>
                </a:lnTo>
                <a:lnTo>
                  <a:pt x="1271521" y="94940"/>
                </a:lnTo>
                <a:lnTo>
                  <a:pt x="1272540" y="155448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3" name="object 163"/>
          <p:cNvSpPr/>
          <p:nvPr/>
        </p:nvSpPr>
        <p:spPr>
          <a:xfrm>
            <a:off x="9244583" y="1931670"/>
            <a:ext cx="1272540" cy="155575"/>
          </a:xfrm>
          <a:custGeom>
            <a:avLst/>
            <a:gdLst/>
            <a:ahLst/>
            <a:cxnLst/>
            <a:rect l="l" t="t" r="r" b="b"/>
            <a:pathLst>
              <a:path w="1272540" h="155575">
                <a:moveTo>
                  <a:pt x="0" y="155448"/>
                </a:moveTo>
                <a:lnTo>
                  <a:pt x="1018" y="94940"/>
                </a:lnTo>
                <a:lnTo>
                  <a:pt x="3795" y="45529"/>
                </a:lnTo>
                <a:lnTo>
                  <a:pt x="7913" y="12215"/>
                </a:lnTo>
                <a:lnTo>
                  <a:pt x="12954" y="0"/>
                </a:lnTo>
                <a:lnTo>
                  <a:pt x="1259586" y="0"/>
                </a:lnTo>
                <a:lnTo>
                  <a:pt x="1264626" y="12215"/>
                </a:lnTo>
                <a:lnTo>
                  <a:pt x="1268744" y="45529"/>
                </a:lnTo>
                <a:lnTo>
                  <a:pt x="1271521" y="94940"/>
                </a:lnTo>
                <a:lnTo>
                  <a:pt x="1272540" y="155448"/>
                </a:lnTo>
              </a:path>
            </a:pathLst>
          </a:custGeom>
          <a:ln w="609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4" name="object 164"/>
          <p:cNvSpPr txBox="1"/>
          <p:nvPr/>
        </p:nvSpPr>
        <p:spPr>
          <a:xfrm>
            <a:off x="59499" y="2718709"/>
            <a:ext cx="165100" cy="53594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145"/>
              </a:lnSpc>
            </a:pPr>
            <a:r>
              <a:rPr sz="1100" spc="-5" dirty="0">
                <a:latin typeface="Calibri"/>
                <a:cs typeface="Calibri"/>
              </a:rPr>
              <a:t>log2ratio</a:t>
            </a:r>
            <a:endParaRPr sz="1100">
              <a:latin typeface="Calibri"/>
              <a:cs typeface="Calibri"/>
            </a:endParaRPr>
          </a:p>
        </p:txBody>
      </p:sp>
      <p:sp>
        <p:nvSpPr>
          <p:cNvPr id="165" name="TextBox 89">
            <a:extLst>
              <a:ext uri="{FF2B5EF4-FFF2-40B4-BE49-F238E27FC236}">
                <a16:creationId xmlns:a16="http://schemas.microsoft.com/office/drawing/2014/main" id="{96CB5D5F-F477-4FC8-BA50-0BE372364FAC}"/>
              </a:ext>
            </a:extLst>
          </p:cNvPr>
          <p:cNvSpPr txBox="1"/>
          <p:nvPr/>
        </p:nvSpPr>
        <p:spPr>
          <a:xfrm>
            <a:off x="535050" y="722856"/>
            <a:ext cx="1047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igure.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A2C6018-3720-CB0B-80FD-C63B2E69F2F8}"/>
              </a:ext>
            </a:extLst>
          </p:cNvPr>
          <p:cNvSpPr txBox="1"/>
          <p:nvPr/>
        </p:nvSpPr>
        <p:spPr>
          <a:xfrm>
            <a:off x="649160" y="5430640"/>
            <a:ext cx="111469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Expression of WNT pathway members WNT7B and TCF20 was altered upon IL-11Rα knockdown as measured by microarray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ults are shown as log2 ratio scores. P – parental cells; WT – wild-type cells; C1, G2, H2, and H8 –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RNA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sed for knockdown of IL-11Rα;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vr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– averag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varajan,Eswaran</dc:creator>
  <cp:lastModifiedBy>Devarajan,Eswaran</cp:lastModifiedBy>
  <cp:revision>3</cp:revision>
  <dcterms:created xsi:type="dcterms:W3CDTF">2022-11-10T17:09:48Z</dcterms:created>
  <dcterms:modified xsi:type="dcterms:W3CDTF">2024-04-11T15:37:35Z</dcterms:modified>
</cp:coreProperties>
</file>